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1068" y="49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henotypic%20Data\CVE%20Response%20to%20Selection%20DN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henotypic%20Data\CVE%20Response%20to%20Selection%20DN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henotypic%20Data\CVE%20Response%20to%20Selection%20DN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henotypic%20Data\Response%20to%20Selection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henotypic%20Data\Response%20to%20Selection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hl-share.nhlbi.nih.gov\DIRHome\harbisonst\Aim%20I%20Artificial%20Selection\Phenotypic%20Data\Response%20to%20Selec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avgboutd_CVE!$B$1</c:f>
              <c:strCache>
                <c:ptCount val="1"/>
                <c:pt idx="0">
                  <c:v>avgboutd C1 1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xVal>
            <c:numRef>
              <c:f>avgboutd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_CVE!$B$2:$B$15</c:f>
              <c:numCache>
                <c:formatCode>General</c:formatCode>
                <c:ptCount val="14"/>
                <c:pt idx="0">
                  <c:v>68.948395199999993</c:v>
                </c:pt>
                <c:pt idx="1">
                  <c:v>222.23226446999999</c:v>
                </c:pt>
                <c:pt idx="2">
                  <c:v>246.01480792000001</c:v>
                </c:pt>
                <c:pt idx="3">
                  <c:v>65.269638224999994</c:v>
                </c:pt>
                <c:pt idx="4">
                  <c:v>105.46635855</c:v>
                </c:pt>
                <c:pt idx="5">
                  <c:v>204.27026182</c:v>
                </c:pt>
                <c:pt idx="6">
                  <c:v>195.50559271</c:v>
                </c:pt>
                <c:pt idx="7">
                  <c:v>292.00150836</c:v>
                </c:pt>
                <c:pt idx="8">
                  <c:v>82.643517990000007</c:v>
                </c:pt>
                <c:pt idx="9">
                  <c:v>306.39545779999997</c:v>
                </c:pt>
                <c:pt idx="10">
                  <c:v>219.33517986999999</c:v>
                </c:pt>
                <c:pt idx="11">
                  <c:v>57.811834640999997</c:v>
                </c:pt>
                <c:pt idx="12">
                  <c:v>50.580704634</c:v>
                </c:pt>
                <c:pt idx="13">
                  <c:v>52.7548660870000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avgboutd_CVE!$C$1</c:f>
              <c:strCache>
                <c:ptCount val="1"/>
                <c:pt idx="0">
                  <c:v>avgboutd C2 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avgboutd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_CVE!$C$2:$C$15</c:f>
              <c:numCache>
                <c:formatCode>General</c:formatCode>
                <c:ptCount val="14"/>
                <c:pt idx="0">
                  <c:v>157.62025961000001</c:v>
                </c:pt>
                <c:pt idx="1">
                  <c:v>39.358788879000002</c:v>
                </c:pt>
                <c:pt idx="2">
                  <c:v>173.35578964000001</c:v>
                </c:pt>
                <c:pt idx="3">
                  <c:v>196.99684167000001</c:v>
                </c:pt>
                <c:pt idx="4">
                  <c:v>198.41967593999999</c:v>
                </c:pt>
                <c:pt idx="5">
                  <c:v>158.9276204</c:v>
                </c:pt>
                <c:pt idx="6">
                  <c:v>110.84047809</c:v>
                </c:pt>
                <c:pt idx="7">
                  <c:v>225.74473707000001</c:v>
                </c:pt>
                <c:pt idx="8">
                  <c:v>49.967641620000002</c:v>
                </c:pt>
                <c:pt idx="9">
                  <c:v>64.409361867000001</c:v>
                </c:pt>
                <c:pt idx="10">
                  <c:v>138.12276781</c:v>
                </c:pt>
                <c:pt idx="11">
                  <c:v>130.72264776</c:v>
                </c:pt>
                <c:pt idx="12">
                  <c:v>212.29469244000001</c:v>
                </c:pt>
                <c:pt idx="13">
                  <c:v>59.62092187700000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avgboutd_CVE!$D$1</c:f>
              <c:strCache>
                <c:ptCount val="1"/>
                <c:pt idx="0">
                  <c:v>avgboutd L1 1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</c:spPr>
          </c:marker>
          <c:xVal>
            <c:numRef>
              <c:f>avgboutd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_CVE!$D$2:$D$15</c:f>
              <c:numCache>
                <c:formatCode>General</c:formatCode>
                <c:ptCount val="14"/>
                <c:pt idx="0">
                  <c:v>80.739749093</c:v>
                </c:pt>
                <c:pt idx="1">
                  <c:v>52.435641224000001</c:v>
                </c:pt>
                <c:pt idx="2">
                  <c:v>67.495266201999996</c:v>
                </c:pt>
                <c:pt idx="3">
                  <c:v>75.006105020999996</c:v>
                </c:pt>
                <c:pt idx="4">
                  <c:v>138.61872314999999</c:v>
                </c:pt>
                <c:pt idx="5">
                  <c:v>87.542078054000001</c:v>
                </c:pt>
                <c:pt idx="6">
                  <c:v>156.85321518000001</c:v>
                </c:pt>
                <c:pt idx="7">
                  <c:v>60.58009148</c:v>
                </c:pt>
                <c:pt idx="8">
                  <c:v>153.80465953000001</c:v>
                </c:pt>
                <c:pt idx="9">
                  <c:v>156.69987817000001</c:v>
                </c:pt>
                <c:pt idx="10">
                  <c:v>133.49410097000001</c:v>
                </c:pt>
                <c:pt idx="11">
                  <c:v>76.743742061000006</c:v>
                </c:pt>
                <c:pt idx="12">
                  <c:v>73.773650840000002</c:v>
                </c:pt>
                <c:pt idx="13">
                  <c:v>82.996590914999999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avgboutd_CVE!$E$1</c:f>
              <c:strCache>
                <c:ptCount val="1"/>
                <c:pt idx="0">
                  <c:v>avgboutd L2 2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triang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numRef>
              <c:f>avgboutd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_CVE!$E$2:$E$15</c:f>
              <c:numCache>
                <c:formatCode>General</c:formatCode>
                <c:ptCount val="14"/>
                <c:pt idx="0">
                  <c:v>50.258352719000001</c:v>
                </c:pt>
                <c:pt idx="1">
                  <c:v>51.163477933000003</c:v>
                </c:pt>
                <c:pt idx="2">
                  <c:v>221.15206967</c:v>
                </c:pt>
                <c:pt idx="3">
                  <c:v>67.124828043999997</c:v>
                </c:pt>
                <c:pt idx="4">
                  <c:v>168.78637042</c:v>
                </c:pt>
                <c:pt idx="5">
                  <c:v>74.865146068000001</c:v>
                </c:pt>
                <c:pt idx="6">
                  <c:v>118.26780601</c:v>
                </c:pt>
                <c:pt idx="7">
                  <c:v>64.677710274999995</c:v>
                </c:pt>
                <c:pt idx="8">
                  <c:v>74.945494224000001</c:v>
                </c:pt>
                <c:pt idx="9">
                  <c:v>78.854311741000004</c:v>
                </c:pt>
                <c:pt idx="10">
                  <c:v>87.162051309999995</c:v>
                </c:pt>
                <c:pt idx="11">
                  <c:v>170.75765036000001</c:v>
                </c:pt>
                <c:pt idx="12">
                  <c:v>68.712774679999995</c:v>
                </c:pt>
                <c:pt idx="13">
                  <c:v>63.769504195000003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avgboutd_CVE!$F$1</c:f>
              <c:strCache>
                <c:ptCount val="1"/>
                <c:pt idx="0">
                  <c:v>avgboutd S1 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numRef>
              <c:f>avgboutd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_CVE!$F$2:$F$15</c:f>
              <c:numCache>
                <c:formatCode>General</c:formatCode>
                <c:ptCount val="14"/>
                <c:pt idx="0">
                  <c:v>55.389888589000002</c:v>
                </c:pt>
                <c:pt idx="1">
                  <c:v>219.14359687999999</c:v>
                </c:pt>
                <c:pt idx="2">
                  <c:v>178.23617350000001</c:v>
                </c:pt>
                <c:pt idx="3">
                  <c:v>275.96749930999999</c:v>
                </c:pt>
                <c:pt idx="4">
                  <c:v>206.39405830000001</c:v>
                </c:pt>
                <c:pt idx="5">
                  <c:v>226.45350822</c:v>
                </c:pt>
                <c:pt idx="6">
                  <c:v>145.15697610999999</c:v>
                </c:pt>
                <c:pt idx="7">
                  <c:v>204.25044037000001</c:v>
                </c:pt>
                <c:pt idx="8">
                  <c:v>84.769683803999996</c:v>
                </c:pt>
                <c:pt idx="9">
                  <c:v>142.91669974999999</c:v>
                </c:pt>
                <c:pt idx="10">
                  <c:v>178.74180533000001</c:v>
                </c:pt>
                <c:pt idx="11">
                  <c:v>51.358027436999997</c:v>
                </c:pt>
                <c:pt idx="12">
                  <c:v>51.755641402000002</c:v>
                </c:pt>
                <c:pt idx="13">
                  <c:v>96.730864089999997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avgboutd_CVE!$G$1</c:f>
              <c:strCache>
                <c:ptCount val="1"/>
                <c:pt idx="0">
                  <c:v>avgboutd S2 2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avgboutd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_CVE!$G$2:$G$15</c:f>
              <c:numCache>
                <c:formatCode>General</c:formatCode>
                <c:ptCount val="14"/>
                <c:pt idx="0">
                  <c:v>147.69954718</c:v>
                </c:pt>
                <c:pt idx="1">
                  <c:v>50.347051723</c:v>
                </c:pt>
                <c:pt idx="2">
                  <c:v>245.57903464</c:v>
                </c:pt>
                <c:pt idx="3">
                  <c:v>234.09726476</c:v>
                </c:pt>
                <c:pt idx="4">
                  <c:v>200.68591634000001</c:v>
                </c:pt>
                <c:pt idx="5">
                  <c:v>115.34048905</c:v>
                </c:pt>
                <c:pt idx="6">
                  <c:v>64.669056792999996</c:v>
                </c:pt>
                <c:pt idx="7">
                  <c:v>226.63673394</c:v>
                </c:pt>
                <c:pt idx="8">
                  <c:v>206.36510952</c:v>
                </c:pt>
                <c:pt idx="9">
                  <c:v>188.38753455</c:v>
                </c:pt>
                <c:pt idx="10">
                  <c:v>196.15796180999999</c:v>
                </c:pt>
                <c:pt idx="11">
                  <c:v>196.47512062999999</c:v>
                </c:pt>
                <c:pt idx="12">
                  <c:v>66.205070624000001</c:v>
                </c:pt>
                <c:pt idx="13">
                  <c:v>47.690834631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0432512"/>
        <c:axId val="120442880"/>
      </c:scatterChart>
      <c:valAx>
        <c:axId val="120432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0442880"/>
        <c:crosses val="autoZero"/>
        <c:crossBetween val="midCat"/>
      </c:valAx>
      <c:valAx>
        <c:axId val="1204428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043251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boutn_CVE!$B$1</c:f>
              <c:strCache>
                <c:ptCount val="1"/>
                <c:pt idx="0">
                  <c:v>boutn C1 1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</c:spPr>
          </c:marker>
          <c:xVal>
            <c:numRef>
              <c:f>boutn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_CVE!$B$2:$B$15</c:f>
              <c:numCache>
                <c:formatCode>General</c:formatCode>
                <c:ptCount val="14"/>
                <c:pt idx="0">
                  <c:v>56.479842083999998</c:v>
                </c:pt>
                <c:pt idx="1">
                  <c:v>46.330679170000003</c:v>
                </c:pt>
                <c:pt idx="2">
                  <c:v>50.683169716999998</c:v>
                </c:pt>
                <c:pt idx="3">
                  <c:v>47.190360169999998</c:v>
                </c:pt>
                <c:pt idx="4">
                  <c:v>48.944171568000002</c:v>
                </c:pt>
                <c:pt idx="5">
                  <c:v>52.742221827000002</c:v>
                </c:pt>
                <c:pt idx="6">
                  <c:v>47.470405571999997</c:v>
                </c:pt>
                <c:pt idx="7">
                  <c:v>42.436766362999997</c:v>
                </c:pt>
                <c:pt idx="8">
                  <c:v>50.562846888000003</c:v>
                </c:pt>
                <c:pt idx="9">
                  <c:v>49.930925549000001</c:v>
                </c:pt>
                <c:pt idx="10">
                  <c:v>46.909969736999997</c:v>
                </c:pt>
                <c:pt idx="11">
                  <c:v>46.803254695</c:v>
                </c:pt>
                <c:pt idx="12">
                  <c:v>44.366442776</c:v>
                </c:pt>
                <c:pt idx="13">
                  <c:v>43.34461661800000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boutn_CVE!$C$1</c:f>
              <c:strCache>
                <c:ptCount val="1"/>
                <c:pt idx="0">
                  <c:v>boutn C2 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boutn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_CVE!$C$2:$C$15</c:f>
              <c:numCache>
                <c:formatCode>General</c:formatCode>
                <c:ptCount val="14"/>
                <c:pt idx="0">
                  <c:v>49.417851966999997</c:v>
                </c:pt>
                <c:pt idx="1">
                  <c:v>44.962651596000001</c:v>
                </c:pt>
                <c:pt idx="2">
                  <c:v>49.330923628999997</c:v>
                </c:pt>
                <c:pt idx="3">
                  <c:v>50.383774363000001</c:v>
                </c:pt>
                <c:pt idx="4">
                  <c:v>47.176771359999996</c:v>
                </c:pt>
                <c:pt idx="5">
                  <c:v>40.772257969999998</c:v>
                </c:pt>
                <c:pt idx="6">
                  <c:v>39.105870000000003</c:v>
                </c:pt>
                <c:pt idx="7">
                  <c:v>41.279615761000002</c:v>
                </c:pt>
                <c:pt idx="8">
                  <c:v>47.847983462000002</c:v>
                </c:pt>
                <c:pt idx="9">
                  <c:v>50.796237935000001</c:v>
                </c:pt>
                <c:pt idx="10">
                  <c:v>51.190737487</c:v>
                </c:pt>
                <c:pt idx="11">
                  <c:v>49.67345152</c:v>
                </c:pt>
                <c:pt idx="12">
                  <c:v>55.588126594999999</c:v>
                </c:pt>
                <c:pt idx="13">
                  <c:v>48.73736832099999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boutn_CVE!$D$1</c:f>
              <c:strCache>
                <c:ptCount val="1"/>
                <c:pt idx="0">
                  <c:v>boutn L1 1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</c:spPr>
          </c:marker>
          <c:xVal>
            <c:numRef>
              <c:f>boutn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_CVE!$D$2:$D$15</c:f>
              <c:numCache>
                <c:formatCode>General</c:formatCode>
                <c:ptCount val="14"/>
                <c:pt idx="0">
                  <c:v>42.734809196999997</c:v>
                </c:pt>
                <c:pt idx="1">
                  <c:v>50.407707268000003</c:v>
                </c:pt>
                <c:pt idx="2">
                  <c:v>60.619550785999998</c:v>
                </c:pt>
                <c:pt idx="3">
                  <c:v>62.285212365</c:v>
                </c:pt>
                <c:pt idx="4">
                  <c:v>70.328431770999998</c:v>
                </c:pt>
                <c:pt idx="5">
                  <c:v>67.039547768000006</c:v>
                </c:pt>
                <c:pt idx="6">
                  <c:v>84.430799550000003</c:v>
                </c:pt>
                <c:pt idx="7">
                  <c:v>75.349068029999998</c:v>
                </c:pt>
                <c:pt idx="8">
                  <c:v>89.095619658999993</c:v>
                </c:pt>
                <c:pt idx="9">
                  <c:v>85.053709421999997</c:v>
                </c:pt>
                <c:pt idx="10">
                  <c:v>87.950233815999994</c:v>
                </c:pt>
                <c:pt idx="11">
                  <c:v>95.976690290999997</c:v>
                </c:pt>
                <c:pt idx="12">
                  <c:v>87.490029901</c:v>
                </c:pt>
                <c:pt idx="13">
                  <c:v>84.167717601000007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boutn_CVE!$E$1</c:f>
              <c:strCache>
                <c:ptCount val="1"/>
                <c:pt idx="0">
                  <c:v>boutn L2 2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triangle"/>
            <c:size val="4"/>
            <c:spPr>
              <a:solidFill>
                <a:srgbClr val="0000FF"/>
              </a:solidFill>
            </c:spPr>
          </c:marker>
          <c:xVal>
            <c:numRef>
              <c:f>boutn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_CVE!$E$2:$E$15</c:f>
              <c:numCache>
                <c:formatCode>General</c:formatCode>
                <c:ptCount val="14"/>
                <c:pt idx="0">
                  <c:v>45.147632373</c:v>
                </c:pt>
                <c:pt idx="1">
                  <c:v>52.671766398000003</c:v>
                </c:pt>
                <c:pt idx="2">
                  <c:v>58.757236122999998</c:v>
                </c:pt>
                <c:pt idx="3">
                  <c:v>63.68232742</c:v>
                </c:pt>
                <c:pt idx="4">
                  <c:v>58.837544284000003</c:v>
                </c:pt>
                <c:pt idx="5">
                  <c:v>57.876034832000002</c:v>
                </c:pt>
                <c:pt idx="6">
                  <c:v>48.555755226999999</c:v>
                </c:pt>
                <c:pt idx="7">
                  <c:v>64.3787454</c:v>
                </c:pt>
                <c:pt idx="8">
                  <c:v>87.597527454000002</c:v>
                </c:pt>
                <c:pt idx="9">
                  <c:v>67.484122447999994</c:v>
                </c:pt>
                <c:pt idx="10">
                  <c:v>78.232069068000001</c:v>
                </c:pt>
                <c:pt idx="11">
                  <c:v>75.871252056000003</c:v>
                </c:pt>
                <c:pt idx="12">
                  <c:v>70.407289786999996</c:v>
                </c:pt>
                <c:pt idx="13">
                  <c:v>88.401544884000003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boutn_CVE!$F$1</c:f>
              <c:strCache>
                <c:ptCount val="1"/>
                <c:pt idx="0">
                  <c:v>boutn S1 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numRef>
              <c:f>boutn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_CVE!$F$2:$F$15</c:f>
              <c:numCache>
                <c:formatCode>General</c:formatCode>
                <c:ptCount val="14"/>
                <c:pt idx="0">
                  <c:v>52.213437724000002</c:v>
                </c:pt>
                <c:pt idx="1">
                  <c:v>45.701926557999997</c:v>
                </c:pt>
                <c:pt idx="2">
                  <c:v>49.653624163000003</c:v>
                </c:pt>
                <c:pt idx="3">
                  <c:v>53.853075939</c:v>
                </c:pt>
                <c:pt idx="4">
                  <c:v>55.124602117999999</c:v>
                </c:pt>
                <c:pt idx="5">
                  <c:v>67.278348297999997</c:v>
                </c:pt>
                <c:pt idx="6">
                  <c:v>66.263500965999995</c:v>
                </c:pt>
                <c:pt idx="7">
                  <c:v>98.502889964999994</c:v>
                </c:pt>
                <c:pt idx="8">
                  <c:v>100.06808062</c:v>
                </c:pt>
                <c:pt idx="9">
                  <c:v>75.708978856000002</c:v>
                </c:pt>
                <c:pt idx="10">
                  <c:v>76.161524579000002</c:v>
                </c:pt>
                <c:pt idx="11">
                  <c:v>61.93445861</c:v>
                </c:pt>
                <c:pt idx="12">
                  <c:v>77.408166312000006</c:v>
                </c:pt>
                <c:pt idx="13">
                  <c:v>68.702994830999998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boutn_CVE!$G$1</c:f>
              <c:strCache>
                <c:ptCount val="1"/>
                <c:pt idx="0">
                  <c:v>boutn S2 2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boutn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_CVE!$G$2:$G$15</c:f>
              <c:numCache>
                <c:formatCode>General</c:formatCode>
                <c:ptCount val="14"/>
                <c:pt idx="0">
                  <c:v>52.404827427000001</c:v>
                </c:pt>
                <c:pt idx="1">
                  <c:v>35.934404419000003</c:v>
                </c:pt>
                <c:pt idx="2">
                  <c:v>47.308159883000002</c:v>
                </c:pt>
                <c:pt idx="3">
                  <c:v>48.33052086</c:v>
                </c:pt>
                <c:pt idx="4">
                  <c:v>43.516734974000002</c:v>
                </c:pt>
                <c:pt idx="5">
                  <c:v>48.779632171999999</c:v>
                </c:pt>
                <c:pt idx="6">
                  <c:v>56.700765609999998</c:v>
                </c:pt>
                <c:pt idx="7">
                  <c:v>69.146567855000001</c:v>
                </c:pt>
                <c:pt idx="8">
                  <c:v>93.417571823000003</c:v>
                </c:pt>
                <c:pt idx="9">
                  <c:v>72.916052011999994</c:v>
                </c:pt>
                <c:pt idx="10">
                  <c:v>61.338906338999998</c:v>
                </c:pt>
                <c:pt idx="11">
                  <c:v>86.121438304999998</c:v>
                </c:pt>
                <c:pt idx="12">
                  <c:v>110.43743562</c:v>
                </c:pt>
                <c:pt idx="13">
                  <c:v>95.87081260399999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7888000"/>
        <c:axId val="127894272"/>
      </c:scatterChart>
      <c:valAx>
        <c:axId val="127888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127894272"/>
        <c:crosses val="autoZero"/>
        <c:crossBetween val="midCat"/>
      </c:valAx>
      <c:valAx>
        <c:axId val="127894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788800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waking_activity_CVE!$B$1</c:f>
              <c:strCache>
                <c:ptCount val="1"/>
                <c:pt idx="0">
                  <c:v>wakeact C1 1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xVal>
            <c:numRef>
              <c:f>waking_activity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ing_activity_CVE!$B$2:$B$15</c:f>
              <c:numCache>
                <c:formatCode>General</c:formatCode>
                <c:ptCount val="14"/>
                <c:pt idx="0">
                  <c:v>20.133305235000002</c:v>
                </c:pt>
                <c:pt idx="1">
                  <c:v>21.852886457</c:v>
                </c:pt>
                <c:pt idx="2">
                  <c:v>21.937955090999999</c:v>
                </c:pt>
                <c:pt idx="3">
                  <c:v>21.422122655999999</c:v>
                </c:pt>
                <c:pt idx="4">
                  <c:v>20.604091906000001</c:v>
                </c:pt>
                <c:pt idx="5">
                  <c:v>24.635434648</c:v>
                </c:pt>
                <c:pt idx="6">
                  <c:v>30.462095123000001</c:v>
                </c:pt>
                <c:pt idx="7">
                  <c:v>22.961783935</c:v>
                </c:pt>
                <c:pt idx="8">
                  <c:v>30.024228306000001</c:v>
                </c:pt>
                <c:pt idx="9">
                  <c:v>23.011911264999998</c:v>
                </c:pt>
                <c:pt idx="10">
                  <c:v>26.547151063000001</c:v>
                </c:pt>
                <c:pt idx="11">
                  <c:v>20.652091481999999</c:v>
                </c:pt>
                <c:pt idx="12">
                  <c:v>20.671491875000001</c:v>
                </c:pt>
                <c:pt idx="13">
                  <c:v>22.60167628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waking_activity_CVE!$C$1</c:f>
              <c:strCache>
                <c:ptCount val="1"/>
                <c:pt idx="0">
                  <c:v>wakeact C2 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waking_activity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ing_activity_CVE!$C$2:$C$15</c:f>
              <c:numCache>
                <c:formatCode>General</c:formatCode>
                <c:ptCount val="14"/>
                <c:pt idx="0">
                  <c:v>21.415000808999999</c:v>
                </c:pt>
                <c:pt idx="1">
                  <c:v>22.032587169999999</c:v>
                </c:pt>
                <c:pt idx="2">
                  <c:v>21.302700260000002</c:v>
                </c:pt>
                <c:pt idx="3">
                  <c:v>28.394516616000001</c:v>
                </c:pt>
                <c:pt idx="4">
                  <c:v>23.179141951999998</c:v>
                </c:pt>
                <c:pt idx="5">
                  <c:v>20.558708472999999</c:v>
                </c:pt>
                <c:pt idx="6">
                  <c:v>22.194529362000001</c:v>
                </c:pt>
                <c:pt idx="7">
                  <c:v>23.259994995</c:v>
                </c:pt>
                <c:pt idx="8">
                  <c:v>21.177956816999998</c:v>
                </c:pt>
                <c:pt idx="9">
                  <c:v>24.967638617999999</c:v>
                </c:pt>
                <c:pt idx="10">
                  <c:v>37.885248713999999</c:v>
                </c:pt>
                <c:pt idx="11">
                  <c:v>27.323311208</c:v>
                </c:pt>
                <c:pt idx="12">
                  <c:v>30.149642319000002</c:v>
                </c:pt>
                <c:pt idx="13">
                  <c:v>26.68329085399999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waking_activity_CVE!$D$1</c:f>
              <c:strCache>
                <c:ptCount val="1"/>
                <c:pt idx="0">
                  <c:v>wakeact L1 1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</c:spPr>
          </c:marker>
          <c:xVal>
            <c:numRef>
              <c:f>waking_activity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ing_activity_CVE!$D$2:$D$15</c:f>
              <c:numCache>
                <c:formatCode>General</c:formatCode>
                <c:ptCount val="14"/>
                <c:pt idx="0">
                  <c:v>20.753799793999999</c:v>
                </c:pt>
                <c:pt idx="1">
                  <c:v>29.463095792000001</c:v>
                </c:pt>
                <c:pt idx="2">
                  <c:v>21.891822488999999</c:v>
                </c:pt>
                <c:pt idx="3">
                  <c:v>20.154400207999998</c:v>
                </c:pt>
                <c:pt idx="4">
                  <c:v>24.639809654</c:v>
                </c:pt>
                <c:pt idx="5">
                  <c:v>22.771445573000001</c:v>
                </c:pt>
                <c:pt idx="6">
                  <c:v>29.241080939</c:v>
                </c:pt>
                <c:pt idx="7">
                  <c:v>27.419119929000001</c:v>
                </c:pt>
                <c:pt idx="8">
                  <c:v>28.998013440000001</c:v>
                </c:pt>
                <c:pt idx="9">
                  <c:v>26.230924653999999</c:v>
                </c:pt>
                <c:pt idx="10">
                  <c:v>30.687011097999999</c:v>
                </c:pt>
                <c:pt idx="11">
                  <c:v>96.005860182000006</c:v>
                </c:pt>
                <c:pt idx="12">
                  <c:v>33.062434857</c:v>
                </c:pt>
                <c:pt idx="13">
                  <c:v>24.90811872800000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waking_activity_CVE!$E$1</c:f>
              <c:strCache>
                <c:ptCount val="1"/>
                <c:pt idx="0">
                  <c:v>wakeact L2 2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xVal>
            <c:numRef>
              <c:f>waking_activity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ing_activity_CVE!$E$2:$E$15</c:f>
              <c:numCache>
                <c:formatCode>General</c:formatCode>
                <c:ptCount val="14"/>
                <c:pt idx="0">
                  <c:v>23.178600536000001</c:v>
                </c:pt>
                <c:pt idx="1">
                  <c:v>20.943398775999999</c:v>
                </c:pt>
                <c:pt idx="2">
                  <c:v>23.130498481</c:v>
                </c:pt>
                <c:pt idx="3">
                  <c:v>21.611269295</c:v>
                </c:pt>
                <c:pt idx="4">
                  <c:v>25.083569164</c:v>
                </c:pt>
                <c:pt idx="5">
                  <c:v>26.096989527000002</c:v>
                </c:pt>
                <c:pt idx="6">
                  <c:v>26.046294781</c:v>
                </c:pt>
                <c:pt idx="7">
                  <c:v>22.110491484000001</c:v>
                </c:pt>
                <c:pt idx="8">
                  <c:v>22.093603291000001</c:v>
                </c:pt>
                <c:pt idx="9">
                  <c:v>31.744393307999999</c:v>
                </c:pt>
                <c:pt idx="10">
                  <c:v>20.434419301999998</c:v>
                </c:pt>
                <c:pt idx="11">
                  <c:v>33.678586662000001</c:v>
                </c:pt>
                <c:pt idx="12">
                  <c:v>25.998501385000001</c:v>
                </c:pt>
                <c:pt idx="13">
                  <c:v>32.285548067999997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waking_activity_CVE!$F$1</c:f>
              <c:strCache>
                <c:ptCount val="1"/>
                <c:pt idx="0">
                  <c:v>wakeact S1 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xVal>
            <c:numRef>
              <c:f>waking_activity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ing_activity_CVE!$F$2:$F$15</c:f>
              <c:numCache>
                <c:formatCode>General</c:formatCode>
                <c:ptCount val="14"/>
                <c:pt idx="0">
                  <c:v>18.063809513999999</c:v>
                </c:pt>
                <c:pt idx="1">
                  <c:v>22.565556714</c:v>
                </c:pt>
                <c:pt idx="2">
                  <c:v>19.453054091999999</c:v>
                </c:pt>
                <c:pt idx="3">
                  <c:v>26.283218581</c:v>
                </c:pt>
                <c:pt idx="4">
                  <c:v>30.931479977999999</c:v>
                </c:pt>
                <c:pt idx="5">
                  <c:v>24.299105398999998</c:v>
                </c:pt>
                <c:pt idx="6">
                  <c:v>27.629131101999999</c:v>
                </c:pt>
                <c:pt idx="7">
                  <c:v>25.553487178000001</c:v>
                </c:pt>
                <c:pt idx="8">
                  <c:v>23.775926329000001</c:v>
                </c:pt>
                <c:pt idx="9">
                  <c:v>26.178774762</c:v>
                </c:pt>
                <c:pt idx="10">
                  <c:v>23.316331010999999</c:v>
                </c:pt>
                <c:pt idx="11">
                  <c:v>22.766401121000001</c:v>
                </c:pt>
                <c:pt idx="12">
                  <c:v>21.451402234</c:v>
                </c:pt>
                <c:pt idx="13">
                  <c:v>28.043336014000001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waking_activity_CVE!$G$1</c:f>
              <c:strCache>
                <c:ptCount val="1"/>
                <c:pt idx="0">
                  <c:v>wakeact S2 2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xVal>
            <c:numRef>
              <c:f>waking_activity_CVE!$A$2:$A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ing_activity_CVE!$G$2:$G$15</c:f>
              <c:numCache>
                <c:formatCode>General</c:formatCode>
                <c:ptCount val="14"/>
                <c:pt idx="0">
                  <c:v>21.529662428000002</c:v>
                </c:pt>
                <c:pt idx="1">
                  <c:v>20.400654844000002</c:v>
                </c:pt>
                <c:pt idx="2">
                  <c:v>20.043166234000001</c:v>
                </c:pt>
                <c:pt idx="3">
                  <c:v>25.747037087999999</c:v>
                </c:pt>
                <c:pt idx="4">
                  <c:v>126.23099263</c:v>
                </c:pt>
                <c:pt idx="5">
                  <c:v>22.301585957</c:v>
                </c:pt>
                <c:pt idx="6">
                  <c:v>23.182127208000001</c:v>
                </c:pt>
                <c:pt idx="7">
                  <c:v>27.589872568000001</c:v>
                </c:pt>
                <c:pt idx="8">
                  <c:v>25.584139929999999</c:v>
                </c:pt>
                <c:pt idx="9">
                  <c:v>26.408934651999999</c:v>
                </c:pt>
                <c:pt idx="10">
                  <c:v>25.431703667000001</c:v>
                </c:pt>
                <c:pt idx="11">
                  <c:v>24.516356527999999</c:v>
                </c:pt>
                <c:pt idx="12">
                  <c:v>24.786738001</c:v>
                </c:pt>
                <c:pt idx="13">
                  <c:v>24.86578385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7950208"/>
        <c:axId val="127976960"/>
      </c:scatterChart>
      <c:valAx>
        <c:axId val="127950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7976960"/>
        <c:crosses val="autoZero"/>
        <c:crossBetween val="midCat"/>
      </c:valAx>
      <c:valAx>
        <c:axId val="127976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795020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avgboutd!$C$1</c:f>
              <c:strCache>
                <c:ptCount val="1"/>
                <c:pt idx="0">
                  <c:v>C1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vgboutd!$L$2:$L$15</c:f>
                <c:numCache>
                  <c:formatCode>General</c:formatCode>
                  <c:ptCount val="14"/>
                  <c:pt idx="0">
                    <c:v>1.3211346303</c:v>
                  </c:pt>
                  <c:pt idx="1">
                    <c:v>3.8486461460000001</c:v>
                  </c:pt>
                  <c:pt idx="2">
                    <c:v>5.6350381471000004</c:v>
                  </c:pt>
                  <c:pt idx="3">
                    <c:v>1.4269627449</c:v>
                  </c:pt>
                  <c:pt idx="4">
                    <c:v>1.9549199775999999</c:v>
                  </c:pt>
                  <c:pt idx="5">
                    <c:v>4.4551684377000003</c:v>
                  </c:pt>
                  <c:pt idx="6">
                    <c:v>3.1810235690000002</c:v>
                  </c:pt>
                  <c:pt idx="7">
                    <c:v>4.5030393799999997</c:v>
                  </c:pt>
                  <c:pt idx="8">
                    <c:v>1.8995113921</c:v>
                  </c:pt>
                  <c:pt idx="9">
                    <c:v>5.9278501339999998</c:v>
                  </c:pt>
                  <c:pt idx="10">
                    <c:v>7.1633965917999998</c:v>
                  </c:pt>
                  <c:pt idx="11">
                    <c:v>1.2181127832</c:v>
                  </c:pt>
                  <c:pt idx="12">
                    <c:v>1.3503806965</c:v>
                  </c:pt>
                  <c:pt idx="13">
                    <c:v>1.4992834103999999</c:v>
                  </c:pt>
                </c:numCache>
              </c:numRef>
            </c:plus>
            <c:minus>
              <c:numRef>
                <c:f>avgboutd!$L$2:$L$15</c:f>
                <c:numCache>
                  <c:formatCode>General</c:formatCode>
                  <c:ptCount val="14"/>
                  <c:pt idx="0">
                    <c:v>1.3211346303</c:v>
                  </c:pt>
                  <c:pt idx="1">
                    <c:v>3.8486461460000001</c:v>
                  </c:pt>
                  <c:pt idx="2">
                    <c:v>5.6350381471000004</c:v>
                  </c:pt>
                  <c:pt idx="3">
                    <c:v>1.4269627449</c:v>
                  </c:pt>
                  <c:pt idx="4">
                    <c:v>1.9549199775999999</c:v>
                  </c:pt>
                  <c:pt idx="5">
                    <c:v>4.4551684377000003</c:v>
                  </c:pt>
                  <c:pt idx="6">
                    <c:v>3.1810235690000002</c:v>
                  </c:pt>
                  <c:pt idx="7">
                    <c:v>4.5030393799999997</c:v>
                  </c:pt>
                  <c:pt idx="8">
                    <c:v>1.8995113921</c:v>
                  </c:pt>
                  <c:pt idx="9">
                    <c:v>5.9278501339999998</c:v>
                  </c:pt>
                  <c:pt idx="10">
                    <c:v>7.1633965917999998</c:v>
                  </c:pt>
                  <c:pt idx="11">
                    <c:v>1.2181127832</c:v>
                  </c:pt>
                  <c:pt idx="12">
                    <c:v>1.3503806965</c:v>
                  </c:pt>
                  <c:pt idx="13">
                    <c:v>1.4992834103999999</c:v>
                  </c:pt>
                </c:numCache>
              </c:numRef>
            </c:minus>
          </c:errBars>
          <c:xVal>
            <c:numRef>
              <c:f>avgboutd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!$C$2:$C$15</c:f>
              <c:numCache>
                <c:formatCode>General</c:formatCode>
                <c:ptCount val="14"/>
                <c:pt idx="0">
                  <c:v>20.919317096</c:v>
                </c:pt>
                <c:pt idx="1">
                  <c:v>21.415728786999999</c:v>
                </c:pt>
                <c:pt idx="2">
                  <c:v>33.580149964999997</c:v>
                </c:pt>
                <c:pt idx="3">
                  <c:v>21.388552001000001</c:v>
                </c:pt>
                <c:pt idx="4">
                  <c:v>26.318486043</c:v>
                </c:pt>
                <c:pt idx="5">
                  <c:v>27.797226253000002</c:v>
                </c:pt>
                <c:pt idx="6">
                  <c:v>25.802683552000001</c:v>
                </c:pt>
                <c:pt idx="7">
                  <c:v>22.641696697</c:v>
                </c:pt>
                <c:pt idx="8">
                  <c:v>22.951820661999999</c:v>
                </c:pt>
                <c:pt idx="9">
                  <c:v>29.244492263000001</c:v>
                </c:pt>
                <c:pt idx="10">
                  <c:v>34.663012887999997</c:v>
                </c:pt>
                <c:pt idx="11">
                  <c:v>19.753265952</c:v>
                </c:pt>
                <c:pt idx="12">
                  <c:v>21.485387458999998</c:v>
                </c:pt>
                <c:pt idx="13">
                  <c:v>21.74529716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avgboutd!$D$1</c:f>
              <c:strCache>
                <c:ptCount val="1"/>
                <c:pt idx="0">
                  <c:v>C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vgboutd!$M$2:$M$15</c:f>
                <c:numCache>
                  <c:formatCode>General</c:formatCode>
                  <c:ptCount val="14"/>
                  <c:pt idx="0">
                    <c:v>3.7452206562999999</c:v>
                  </c:pt>
                  <c:pt idx="1">
                    <c:v>0.80285641029999999</c:v>
                  </c:pt>
                  <c:pt idx="2">
                    <c:v>3.2891242972999999</c:v>
                  </c:pt>
                  <c:pt idx="3">
                    <c:v>5.0272455561999996</c:v>
                  </c:pt>
                  <c:pt idx="4">
                    <c:v>4.1606578788000004</c:v>
                  </c:pt>
                  <c:pt idx="5">
                    <c:v>2.1510369348</c:v>
                  </c:pt>
                  <c:pt idx="6">
                    <c:v>3.5936873458999998</c:v>
                  </c:pt>
                  <c:pt idx="7">
                    <c:v>3.6251552973000001</c:v>
                  </c:pt>
                  <c:pt idx="8">
                    <c:v>1.0975485570000001</c:v>
                  </c:pt>
                  <c:pt idx="9">
                    <c:v>1.4909971173000001</c:v>
                  </c:pt>
                  <c:pt idx="10">
                    <c:v>2.4835471995999998</c:v>
                  </c:pt>
                  <c:pt idx="11">
                    <c:v>4.4807646927000002</c:v>
                  </c:pt>
                  <c:pt idx="12">
                    <c:v>4.4587071492000003</c:v>
                  </c:pt>
                  <c:pt idx="13">
                    <c:v>0.83635200430000001</c:v>
                  </c:pt>
                </c:numCache>
              </c:numRef>
            </c:plus>
            <c:minus>
              <c:numRef>
                <c:f>avgboutd!$M$2:$M$15</c:f>
                <c:numCache>
                  <c:formatCode>General</c:formatCode>
                  <c:ptCount val="14"/>
                  <c:pt idx="0">
                    <c:v>3.7452206562999999</c:v>
                  </c:pt>
                  <c:pt idx="1">
                    <c:v>0.80285641029999999</c:v>
                  </c:pt>
                  <c:pt idx="2">
                    <c:v>3.2891242972999999</c:v>
                  </c:pt>
                  <c:pt idx="3">
                    <c:v>5.0272455561999996</c:v>
                  </c:pt>
                  <c:pt idx="4">
                    <c:v>4.1606578788000004</c:v>
                  </c:pt>
                  <c:pt idx="5">
                    <c:v>2.1510369348</c:v>
                  </c:pt>
                  <c:pt idx="6">
                    <c:v>3.5936873458999998</c:v>
                  </c:pt>
                  <c:pt idx="7">
                    <c:v>3.6251552973000001</c:v>
                  </c:pt>
                  <c:pt idx="8">
                    <c:v>1.0975485570000001</c:v>
                  </c:pt>
                  <c:pt idx="9">
                    <c:v>1.4909971173000001</c:v>
                  </c:pt>
                  <c:pt idx="10">
                    <c:v>2.4835471995999998</c:v>
                  </c:pt>
                  <c:pt idx="11">
                    <c:v>4.4807646927000002</c:v>
                  </c:pt>
                  <c:pt idx="12">
                    <c:v>4.4587071492000003</c:v>
                  </c:pt>
                  <c:pt idx="13">
                    <c:v>0.83635200430000001</c:v>
                  </c:pt>
                </c:numCache>
              </c:numRef>
            </c:minus>
          </c:errBars>
          <c:xVal>
            <c:numRef>
              <c:f>avgboutd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!$D$2:$D$15</c:f>
              <c:numCache>
                <c:formatCode>General</c:formatCode>
                <c:ptCount val="14"/>
                <c:pt idx="0">
                  <c:v>24.619062327999998</c:v>
                </c:pt>
                <c:pt idx="1">
                  <c:v>15.920677476</c:v>
                </c:pt>
                <c:pt idx="2">
                  <c:v>23.193256774999998</c:v>
                </c:pt>
                <c:pt idx="3">
                  <c:v>31.297653296</c:v>
                </c:pt>
                <c:pt idx="4">
                  <c:v>27.971936552999999</c:v>
                </c:pt>
                <c:pt idx="5">
                  <c:v>21.218481423</c:v>
                </c:pt>
                <c:pt idx="6">
                  <c:v>43.651155545000002</c:v>
                </c:pt>
                <c:pt idx="7">
                  <c:v>21.011128834000001</c:v>
                </c:pt>
                <c:pt idx="8">
                  <c:v>20.946862930999998</c:v>
                </c:pt>
                <c:pt idx="9">
                  <c:v>20.725965384999999</c:v>
                </c:pt>
                <c:pt idx="10">
                  <c:v>25.962016305999999</c:v>
                </c:pt>
                <c:pt idx="11">
                  <c:v>24.629132254999998</c:v>
                </c:pt>
                <c:pt idx="12">
                  <c:v>24.339128092999999</c:v>
                </c:pt>
                <c:pt idx="13">
                  <c:v>13.93083538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avgboutd!$E$1</c:f>
              <c:strCache>
                <c:ptCount val="1"/>
                <c:pt idx="0">
                  <c:v>L1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vgboutd!$N$2:$N$15</c:f>
                <c:numCache>
                  <c:formatCode>General</c:formatCode>
                  <c:ptCount val="14"/>
                  <c:pt idx="0">
                    <c:v>1.6583902904000001</c:v>
                  </c:pt>
                  <c:pt idx="1">
                    <c:v>0.90974693529999995</c:v>
                  </c:pt>
                  <c:pt idx="2">
                    <c:v>1.4315221249000001</c:v>
                  </c:pt>
                  <c:pt idx="3">
                    <c:v>1.4117538479</c:v>
                  </c:pt>
                  <c:pt idx="4">
                    <c:v>3.6809669213</c:v>
                  </c:pt>
                  <c:pt idx="5">
                    <c:v>2.1262133150000002</c:v>
                  </c:pt>
                  <c:pt idx="6">
                    <c:v>4.2507123132000002</c:v>
                  </c:pt>
                  <c:pt idx="7">
                    <c:v>1.7201714408</c:v>
                  </c:pt>
                  <c:pt idx="8">
                    <c:v>4.2837738258</c:v>
                  </c:pt>
                  <c:pt idx="9">
                    <c:v>4.4715185751000002</c:v>
                  </c:pt>
                  <c:pt idx="10">
                    <c:v>5.1446457951999998</c:v>
                  </c:pt>
                  <c:pt idx="11">
                    <c:v>2.4029866692000001</c:v>
                  </c:pt>
                  <c:pt idx="12">
                    <c:v>3.9420970934000001</c:v>
                  </c:pt>
                  <c:pt idx="13">
                    <c:v>2.9391052658999999</c:v>
                  </c:pt>
                </c:numCache>
              </c:numRef>
            </c:plus>
            <c:minus>
              <c:numRef>
                <c:f>avgboutd!$N$2:$N$15</c:f>
                <c:numCache>
                  <c:formatCode>General</c:formatCode>
                  <c:ptCount val="14"/>
                  <c:pt idx="0">
                    <c:v>1.6583902904000001</c:v>
                  </c:pt>
                  <c:pt idx="1">
                    <c:v>0.90974693529999995</c:v>
                  </c:pt>
                  <c:pt idx="2">
                    <c:v>1.4315221249000001</c:v>
                  </c:pt>
                  <c:pt idx="3">
                    <c:v>1.4117538479</c:v>
                  </c:pt>
                  <c:pt idx="4">
                    <c:v>3.6809669213</c:v>
                  </c:pt>
                  <c:pt idx="5">
                    <c:v>2.1262133150000002</c:v>
                  </c:pt>
                  <c:pt idx="6">
                    <c:v>4.2507123132000002</c:v>
                  </c:pt>
                  <c:pt idx="7">
                    <c:v>1.7201714408</c:v>
                  </c:pt>
                  <c:pt idx="8">
                    <c:v>4.2837738258</c:v>
                  </c:pt>
                  <c:pt idx="9">
                    <c:v>4.4715185751000002</c:v>
                  </c:pt>
                  <c:pt idx="10">
                    <c:v>5.1446457951999998</c:v>
                  </c:pt>
                  <c:pt idx="11">
                    <c:v>2.4029866692000001</c:v>
                  </c:pt>
                  <c:pt idx="12">
                    <c:v>3.9420970934000001</c:v>
                  </c:pt>
                  <c:pt idx="13">
                    <c:v>2.9391052658999999</c:v>
                  </c:pt>
                </c:numCache>
              </c:numRef>
            </c:minus>
          </c:errBars>
          <c:xVal>
            <c:numRef>
              <c:f>avgboutd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!$E$2:$E$15</c:f>
              <c:numCache>
                <c:formatCode>General</c:formatCode>
                <c:ptCount val="14"/>
                <c:pt idx="0">
                  <c:v>18.744389436999999</c:v>
                </c:pt>
                <c:pt idx="1">
                  <c:v>17.820292679000001</c:v>
                </c:pt>
                <c:pt idx="2">
                  <c:v>24.801301725999998</c:v>
                </c:pt>
                <c:pt idx="3">
                  <c:v>23.740649180999998</c:v>
                </c:pt>
                <c:pt idx="4">
                  <c:v>37.337609602999997</c:v>
                </c:pt>
                <c:pt idx="5">
                  <c:v>33.209246198999999</c:v>
                </c:pt>
                <c:pt idx="6">
                  <c:v>40.639412941000003</c:v>
                </c:pt>
                <c:pt idx="7">
                  <c:v>33.443236370000001</c:v>
                </c:pt>
                <c:pt idx="8">
                  <c:v>44.177479317</c:v>
                </c:pt>
                <c:pt idx="9">
                  <c:v>41.940046125999999</c:v>
                </c:pt>
                <c:pt idx="10">
                  <c:v>56.344348920000002</c:v>
                </c:pt>
                <c:pt idx="11">
                  <c:v>37.780773979000003</c:v>
                </c:pt>
                <c:pt idx="12">
                  <c:v>48.825202341000001</c:v>
                </c:pt>
                <c:pt idx="13">
                  <c:v>32.95121491599999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avgboutd!$F$1</c:f>
              <c:strCache>
                <c:ptCount val="1"/>
                <c:pt idx="0">
                  <c:v>L2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triang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vgboutd!$O$2:$O$15</c:f>
                <c:numCache>
                  <c:formatCode>General</c:formatCode>
                  <c:ptCount val="14"/>
                  <c:pt idx="0">
                    <c:v>0.72380234050000003</c:v>
                  </c:pt>
                  <c:pt idx="1">
                    <c:v>1.2110233218999999</c:v>
                  </c:pt>
                  <c:pt idx="2">
                    <c:v>4.1500039090999996</c:v>
                  </c:pt>
                  <c:pt idx="3">
                    <c:v>2.1884212000000001</c:v>
                  </c:pt>
                  <c:pt idx="4">
                    <c:v>3.9839759847999998</c:v>
                  </c:pt>
                  <c:pt idx="5">
                    <c:v>1.9916326853999999</c:v>
                  </c:pt>
                  <c:pt idx="6">
                    <c:v>3.7485376404999999</c:v>
                  </c:pt>
                  <c:pt idx="7">
                    <c:v>1.6533807706999999</c:v>
                  </c:pt>
                  <c:pt idx="8">
                    <c:v>4.1865449939000001</c:v>
                  </c:pt>
                  <c:pt idx="9">
                    <c:v>3.8629147357</c:v>
                  </c:pt>
                  <c:pt idx="10">
                    <c:v>2.6822141013</c:v>
                  </c:pt>
                  <c:pt idx="11">
                    <c:v>3.45484664</c:v>
                  </c:pt>
                  <c:pt idx="12">
                    <c:v>2.0534711496</c:v>
                  </c:pt>
                  <c:pt idx="13">
                    <c:v>1.4492858012000001</c:v>
                  </c:pt>
                </c:numCache>
              </c:numRef>
            </c:plus>
            <c:minus>
              <c:numRef>
                <c:f>avgboutd!$O$2:$O$15</c:f>
                <c:numCache>
                  <c:formatCode>General</c:formatCode>
                  <c:ptCount val="14"/>
                  <c:pt idx="0">
                    <c:v>0.72380234050000003</c:v>
                  </c:pt>
                  <c:pt idx="1">
                    <c:v>1.2110233218999999</c:v>
                  </c:pt>
                  <c:pt idx="2">
                    <c:v>4.1500039090999996</c:v>
                  </c:pt>
                  <c:pt idx="3">
                    <c:v>2.1884212000000001</c:v>
                  </c:pt>
                  <c:pt idx="4">
                    <c:v>3.9839759847999998</c:v>
                  </c:pt>
                  <c:pt idx="5">
                    <c:v>1.9916326853999999</c:v>
                  </c:pt>
                  <c:pt idx="6">
                    <c:v>3.7485376404999999</c:v>
                  </c:pt>
                  <c:pt idx="7">
                    <c:v>1.6533807706999999</c:v>
                  </c:pt>
                  <c:pt idx="8">
                    <c:v>4.1865449939000001</c:v>
                  </c:pt>
                  <c:pt idx="9">
                    <c:v>3.8629147357</c:v>
                  </c:pt>
                  <c:pt idx="10">
                    <c:v>2.6822141013</c:v>
                  </c:pt>
                  <c:pt idx="11">
                    <c:v>3.45484664</c:v>
                  </c:pt>
                  <c:pt idx="12">
                    <c:v>2.0534711496</c:v>
                  </c:pt>
                  <c:pt idx="13">
                    <c:v>1.4492858012000001</c:v>
                  </c:pt>
                </c:numCache>
              </c:numRef>
            </c:minus>
          </c:errBars>
          <c:xVal>
            <c:numRef>
              <c:f>avgboutd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!$F$2:$F$15</c:f>
              <c:numCache>
                <c:formatCode>General</c:formatCode>
                <c:ptCount val="14"/>
                <c:pt idx="0">
                  <c:v>17.802685543999999</c:v>
                </c:pt>
                <c:pt idx="1">
                  <c:v>19.600819275999999</c:v>
                </c:pt>
                <c:pt idx="2">
                  <c:v>29.942617642999998</c:v>
                </c:pt>
                <c:pt idx="3">
                  <c:v>26.221577645</c:v>
                </c:pt>
                <c:pt idx="4">
                  <c:v>31.678502142999999</c:v>
                </c:pt>
                <c:pt idx="5">
                  <c:v>26.413611024000001</c:v>
                </c:pt>
                <c:pt idx="6">
                  <c:v>46.991377354000001</c:v>
                </c:pt>
                <c:pt idx="7">
                  <c:v>26.089280509000002</c:v>
                </c:pt>
                <c:pt idx="8">
                  <c:v>46.307459442000003</c:v>
                </c:pt>
                <c:pt idx="9">
                  <c:v>40.921781457000002</c:v>
                </c:pt>
                <c:pt idx="10">
                  <c:v>32.909474062000001</c:v>
                </c:pt>
                <c:pt idx="11">
                  <c:v>30.579893144</c:v>
                </c:pt>
                <c:pt idx="12">
                  <c:v>26.154100868</c:v>
                </c:pt>
                <c:pt idx="13">
                  <c:v>26.807451131000001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avgboutd!$G$1</c:f>
              <c:strCache>
                <c:ptCount val="1"/>
                <c:pt idx="0">
                  <c:v>S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vgboutd!$P$2:$P$15</c:f>
                <c:numCache>
                  <c:formatCode>General</c:formatCode>
                  <c:ptCount val="14"/>
                  <c:pt idx="0">
                    <c:v>1.1924187606000001</c:v>
                  </c:pt>
                  <c:pt idx="1">
                    <c:v>4.5555075037000003</c:v>
                  </c:pt>
                  <c:pt idx="2">
                    <c:v>1.9886769747999999</c:v>
                  </c:pt>
                  <c:pt idx="3">
                    <c:v>6.7017259013999997</c:v>
                  </c:pt>
                  <c:pt idx="4">
                    <c:v>8.0443027952000001</c:v>
                  </c:pt>
                  <c:pt idx="5">
                    <c:v>3.6627541372999999</c:v>
                  </c:pt>
                  <c:pt idx="6">
                    <c:v>2.8143097247000002</c:v>
                  </c:pt>
                  <c:pt idx="7">
                    <c:v>2.3863698941</c:v>
                  </c:pt>
                  <c:pt idx="8">
                    <c:v>1.1351897180999999</c:v>
                  </c:pt>
                  <c:pt idx="9">
                    <c:v>1.7216599961000001</c:v>
                  </c:pt>
                  <c:pt idx="10">
                    <c:v>3.3667280400999999</c:v>
                  </c:pt>
                  <c:pt idx="11">
                    <c:v>1.0286057182999999</c:v>
                  </c:pt>
                  <c:pt idx="12">
                    <c:v>0.7783743608</c:v>
                  </c:pt>
                  <c:pt idx="13">
                    <c:v>2.0441040514000002</c:v>
                  </c:pt>
                </c:numCache>
              </c:numRef>
            </c:plus>
            <c:minus>
              <c:numRef>
                <c:f>avgboutd!$P$2:$P$15</c:f>
                <c:numCache>
                  <c:formatCode>General</c:formatCode>
                  <c:ptCount val="14"/>
                  <c:pt idx="0">
                    <c:v>1.1924187606000001</c:v>
                  </c:pt>
                  <c:pt idx="1">
                    <c:v>4.5555075037000003</c:v>
                  </c:pt>
                  <c:pt idx="2">
                    <c:v>1.9886769747999999</c:v>
                  </c:pt>
                  <c:pt idx="3">
                    <c:v>6.7017259013999997</c:v>
                  </c:pt>
                  <c:pt idx="4">
                    <c:v>8.0443027952000001</c:v>
                  </c:pt>
                  <c:pt idx="5">
                    <c:v>3.6627541372999999</c:v>
                  </c:pt>
                  <c:pt idx="6">
                    <c:v>2.8143097247000002</c:v>
                  </c:pt>
                  <c:pt idx="7">
                    <c:v>2.3863698941</c:v>
                  </c:pt>
                  <c:pt idx="8">
                    <c:v>1.1351897180999999</c:v>
                  </c:pt>
                  <c:pt idx="9">
                    <c:v>1.7216599961000001</c:v>
                  </c:pt>
                  <c:pt idx="10">
                    <c:v>3.3667280400999999</c:v>
                  </c:pt>
                  <c:pt idx="11">
                    <c:v>1.0286057182999999</c:v>
                  </c:pt>
                  <c:pt idx="12">
                    <c:v>0.7783743608</c:v>
                  </c:pt>
                  <c:pt idx="13">
                    <c:v>2.0441040514000002</c:v>
                  </c:pt>
                </c:numCache>
              </c:numRef>
            </c:minus>
          </c:errBars>
          <c:xVal>
            <c:numRef>
              <c:f>avgboutd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!$G$2:$G$15</c:f>
              <c:numCache>
                <c:formatCode>General</c:formatCode>
                <c:ptCount val="14"/>
                <c:pt idx="0">
                  <c:v>19.776727886</c:v>
                </c:pt>
                <c:pt idx="1">
                  <c:v>21.10327457</c:v>
                </c:pt>
                <c:pt idx="2">
                  <c:v>16.404801356</c:v>
                </c:pt>
                <c:pt idx="3">
                  <c:v>30.700572695999998</c:v>
                </c:pt>
                <c:pt idx="4">
                  <c:v>34.793856628999997</c:v>
                </c:pt>
                <c:pt idx="5">
                  <c:v>16.18336176</c:v>
                </c:pt>
                <c:pt idx="6">
                  <c:v>15.759215915</c:v>
                </c:pt>
                <c:pt idx="7">
                  <c:v>14.916107567999999</c:v>
                </c:pt>
                <c:pt idx="8">
                  <c:v>13.123223088</c:v>
                </c:pt>
                <c:pt idx="9">
                  <c:v>16.136311002999999</c:v>
                </c:pt>
                <c:pt idx="10">
                  <c:v>24.800567633</c:v>
                </c:pt>
                <c:pt idx="11">
                  <c:v>13.450987486000001</c:v>
                </c:pt>
                <c:pt idx="12">
                  <c:v>13.066042103999999</c:v>
                </c:pt>
                <c:pt idx="13">
                  <c:v>13.496774954999999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avgboutd!$H$1</c:f>
              <c:strCache>
                <c:ptCount val="1"/>
                <c:pt idx="0">
                  <c:v>S2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avgboutd!$Q$2:$Q$15</c:f>
                <c:numCache>
                  <c:formatCode>General</c:formatCode>
                  <c:ptCount val="14"/>
                  <c:pt idx="0">
                    <c:v>2.2333954545000001</c:v>
                  </c:pt>
                  <c:pt idx="1">
                    <c:v>0.67580656630000002</c:v>
                  </c:pt>
                  <c:pt idx="2">
                    <c:v>4.0765681001000003</c:v>
                  </c:pt>
                  <c:pt idx="3">
                    <c:v>6.0673431413000003</c:v>
                  </c:pt>
                  <c:pt idx="4">
                    <c:v>5.7392605906999998</c:v>
                  </c:pt>
                  <c:pt idx="5">
                    <c:v>1.1180097569</c:v>
                  </c:pt>
                  <c:pt idx="6">
                    <c:v>3.9054652967000001</c:v>
                  </c:pt>
                  <c:pt idx="7">
                    <c:v>2.7657091915000001</c:v>
                  </c:pt>
                  <c:pt idx="8">
                    <c:v>2.9774857307999998</c:v>
                  </c:pt>
                  <c:pt idx="9">
                    <c:v>2.6201022427999998</c:v>
                  </c:pt>
                  <c:pt idx="10">
                    <c:v>2.9948115989000001</c:v>
                  </c:pt>
                  <c:pt idx="11">
                    <c:v>4.8054360691999998</c:v>
                  </c:pt>
                  <c:pt idx="12">
                    <c:v>0.96146869550000003</c:v>
                  </c:pt>
                  <c:pt idx="13">
                    <c:v>0.61192775649999998</c:v>
                  </c:pt>
                </c:numCache>
              </c:numRef>
            </c:plus>
            <c:minus>
              <c:numRef>
                <c:f>avgboutd!$Q$2:$Q$15</c:f>
                <c:numCache>
                  <c:formatCode>General</c:formatCode>
                  <c:ptCount val="14"/>
                  <c:pt idx="0">
                    <c:v>2.2333954545000001</c:v>
                  </c:pt>
                  <c:pt idx="1">
                    <c:v>0.67580656630000002</c:v>
                  </c:pt>
                  <c:pt idx="2">
                    <c:v>4.0765681001000003</c:v>
                  </c:pt>
                  <c:pt idx="3">
                    <c:v>6.0673431413000003</c:v>
                  </c:pt>
                  <c:pt idx="4">
                    <c:v>5.7392605906999998</c:v>
                  </c:pt>
                  <c:pt idx="5">
                    <c:v>1.1180097569</c:v>
                  </c:pt>
                  <c:pt idx="6">
                    <c:v>3.9054652967000001</c:v>
                  </c:pt>
                  <c:pt idx="7">
                    <c:v>2.7657091915000001</c:v>
                  </c:pt>
                  <c:pt idx="8">
                    <c:v>2.9774857307999998</c:v>
                  </c:pt>
                  <c:pt idx="9">
                    <c:v>2.6201022427999998</c:v>
                  </c:pt>
                  <c:pt idx="10">
                    <c:v>2.9948115989000001</c:v>
                  </c:pt>
                  <c:pt idx="11">
                    <c:v>4.8054360691999998</c:v>
                  </c:pt>
                  <c:pt idx="12">
                    <c:v>0.96146869550000003</c:v>
                  </c:pt>
                  <c:pt idx="13">
                    <c:v>0.61192775649999998</c:v>
                  </c:pt>
                </c:numCache>
              </c:numRef>
            </c:minus>
          </c:errBars>
          <c:xVal>
            <c:numRef>
              <c:f>avgboutd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avgboutd!$H$2:$H$15</c:f>
              <c:numCache>
                <c:formatCode>General</c:formatCode>
                <c:ptCount val="14"/>
                <c:pt idx="0">
                  <c:v>21.794889533999999</c:v>
                </c:pt>
                <c:pt idx="1">
                  <c:v>14.972975218</c:v>
                </c:pt>
                <c:pt idx="2">
                  <c:v>26.417349139999999</c:v>
                </c:pt>
                <c:pt idx="3">
                  <c:v>30.562105732999999</c:v>
                </c:pt>
                <c:pt idx="4">
                  <c:v>24.65539484</c:v>
                </c:pt>
                <c:pt idx="5">
                  <c:v>14.282794376</c:v>
                </c:pt>
                <c:pt idx="6">
                  <c:v>78.978642070000006</c:v>
                </c:pt>
                <c:pt idx="7">
                  <c:v>15.706588986</c:v>
                </c:pt>
                <c:pt idx="8">
                  <c:v>17.279022222999998</c:v>
                </c:pt>
                <c:pt idx="9">
                  <c:v>17.660460063999999</c:v>
                </c:pt>
                <c:pt idx="10">
                  <c:v>16.857270868000001</c:v>
                </c:pt>
                <c:pt idx="11">
                  <c:v>18.821698579</c:v>
                </c:pt>
                <c:pt idx="12">
                  <c:v>12.94580807</c:v>
                </c:pt>
                <c:pt idx="13">
                  <c:v>12.04056947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052224"/>
        <c:axId val="128054016"/>
      </c:scatterChart>
      <c:valAx>
        <c:axId val="128052224"/>
        <c:scaling>
          <c:orientation val="minMax"/>
          <c:max val="13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054016"/>
        <c:crosses val="autoZero"/>
        <c:crossBetween val="midCat"/>
        <c:majorUnit val="2"/>
      </c:valAx>
      <c:valAx>
        <c:axId val="128054016"/>
        <c:scaling>
          <c:orientation val="minMax"/>
          <c:max val="4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052224"/>
        <c:crosses val="autoZero"/>
        <c:crossBetween val="midCat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boutn!$C$1</c:f>
              <c:strCache>
                <c:ptCount val="1"/>
                <c:pt idx="0">
                  <c:v>C1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utn!$L$2:$L$15</c:f>
                <c:numCache>
                  <c:formatCode>General</c:formatCode>
                  <c:ptCount val="14"/>
                  <c:pt idx="0">
                    <c:v>0.51330518920000001</c:v>
                  </c:pt>
                  <c:pt idx="1">
                    <c:v>0.3932312503</c:v>
                  </c:pt>
                  <c:pt idx="2">
                    <c:v>0.4001295232</c:v>
                  </c:pt>
                  <c:pt idx="3">
                    <c:v>0.34598558109999999</c:v>
                  </c:pt>
                  <c:pt idx="4">
                    <c:v>0.39754322069999998</c:v>
                  </c:pt>
                  <c:pt idx="5">
                    <c:v>0.43232302239999998</c:v>
                  </c:pt>
                  <c:pt idx="6">
                    <c:v>0.38332521879999998</c:v>
                  </c:pt>
                  <c:pt idx="7">
                    <c:v>0.49111045860000002</c:v>
                  </c:pt>
                  <c:pt idx="8">
                    <c:v>0.53860850400000004</c:v>
                  </c:pt>
                  <c:pt idx="9">
                    <c:v>0.4766682995</c:v>
                  </c:pt>
                  <c:pt idx="10">
                    <c:v>0.4696683915</c:v>
                  </c:pt>
                  <c:pt idx="11">
                    <c:v>0.53166248859999998</c:v>
                  </c:pt>
                  <c:pt idx="12">
                    <c:v>0.52872885020000004</c:v>
                  </c:pt>
                  <c:pt idx="13">
                    <c:v>0.49779691069999998</c:v>
                  </c:pt>
                </c:numCache>
              </c:numRef>
            </c:plus>
            <c:minus>
              <c:numRef>
                <c:f>boutn!$L$2:$L$15</c:f>
                <c:numCache>
                  <c:formatCode>General</c:formatCode>
                  <c:ptCount val="14"/>
                  <c:pt idx="0">
                    <c:v>0.51330518920000001</c:v>
                  </c:pt>
                  <c:pt idx="1">
                    <c:v>0.3932312503</c:v>
                  </c:pt>
                  <c:pt idx="2">
                    <c:v>0.4001295232</c:v>
                  </c:pt>
                  <c:pt idx="3">
                    <c:v>0.34598558109999999</c:v>
                  </c:pt>
                  <c:pt idx="4">
                    <c:v>0.39754322069999998</c:v>
                  </c:pt>
                  <c:pt idx="5">
                    <c:v>0.43232302239999998</c:v>
                  </c:pt>
                  <c:pt idx="6">
                    <c:v>0.38332521879999998</c:v>
                  </c:pt>
                  <c:pt idx="7">
                    <c:v>0.49111045860000002</c:v>
                  </c:pt>
                  <c:pt idx="8">
                    <c:v>0.53860850400000004</c:v>
                  </c:pt>
                  <c:pt idx="9">
                    <c:v>0.4766682995</c:v>
                  </c:pt>
                  <c:pt idx="10">
                    <c:v>0.4696683915</c:v>
                  </c:pt>
                  <c:pt idx="11">
                    <c:v>0.53166248859999998</c:v>
                  </c:pt>
                  <c:pt idx="12">
                    <c:v>0.52872885020000004</c:v>
                  </c:pt>
                  <c:pt idx="13">
                    <c:v>0.49779691069999998</c:v>
                  </c:pt>
                </c:numCache>
              </c:numRef>
            </c:minus>
          </c:errBars>
          <c:xVal>
            <c:numRef>
              <c:f>boutn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!$C$2:$C$15</c:f>
              <c:numCache>
                <c:formatCode>General</c:formatCode>
                <c:ptCount val="14"/>
                <c:pt idx="0">
                  <c:v>11.611280488</c:v>
                </c:pt>
                <c:pt idx="1">
                  <c:v>11.551020407999999</c:v>
                </c:pt>
                <c:pt idx="2">
                  <c:v>10.876250000000001</c:v>
                </c:pt>
                <c:pt idx="3">
                  <c:v>10.286250000000001</c:v>
                </c:pt>
                <c:pt idx="4">
                  <c:v>10.718592964999999</c:v>
                </c:pt>
                <c:pt idx="5">
                  <c:v>11.19125</c:v>
                </c:pt>
                <c:pt idx="6">
                  <c:v>11.058375635000001</c:v>
                </c:pt>
                <c:pt idx="7">
                  <c:v>15.222361809000001</c:v>
                </c:pt>
                <c:pt idx="8">
                  <c:v>14.22</c:v>
                </c:pt>
                <c:pt idx="9">
                  <c:v>12.487046632</c:v>
                </c:pt>
                <c:pt idx="10">
                  <c:v>12.015536723</c:v>
                </c:pt>
                <c:pt idx="11">
                  <c:v>13.532051281999999</c:v>
                </c:pt>
                <c:pt idx="12">
                  <c:v>13.701807229</c:v>
                </c:pt>
                <c:pt idx="13">
                  <c:v>13.31832298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boutn!$D$1</c:f>
              <c:strCache>
                <c:ptCount val="1"/>
                <c:pt idx="0">
                  <c:v>C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utn!$M$2:$M$15</c:f>
                <c:numCache>
                  <c:formatCode>General</c:formatCode>
                  <c:ptCount val="14"/>
                  <c:pt idx="0">
                    <c:v>0.3941632437</c:v>
                  </c:pt>
                  <c:pt idx="1">
                    <c:v>0.42561047660000001</c:v>
                  </c:pt>
                  <c:pt idx="2">
                    <c:v>0.4101067317</c:v>
                  </c:pt>
                  <c:pt idx="3">
                    <c:v>0.39172802810000001</c:v>
                  </c:pt>
                  <c:pt idx="4">
                    <c:v>0.39153680800000001</c:v>
                  </c:pt>
                  <c:pt idx="5">
                    <c:v>0.407347501</c:v>
                  </c:pt>
                  <c:pt idx="6">
                    <c:v>0.37102159950000002</c:v>
                  </c:pt>
                  <c:pt idx="7">
                    <c:v>0.47731606739999999</c:v>
                  </c:pt>
                  <c:pt idx="8">
                    <c:v>0.44064619020000001</c:v>
                  </c:pt>
                  <c:pt idx="9">
                    <c:v>0.49848134519999998</c:v>
                  </c:pt>
                  <c:pt idx="10">
                    <c:v>0.54442569139999997</c:v>
                  </c:pt>
                  <c:pt idx="11">
                    <c:v>0.43233945359999998</c:v>
                  </c:pt>
                  <c:pt idx="12">
                    <c:v>0.48692051060000002</c:v>
                  </c:pt>
                  <c:pt idx="13">
                    <c:v>0.47620950709999998</c:v>
                  </c:pt>
                </c:numCache>
              </c:numRef>
            </c:plus>
            <c:minus>
              <c:numRef>
                <c:f>boutn!$M$2:$M$15</c:f>
                <c:numCache>
                  <c:formatCode>General</c:formatCode>
                  <c:ptCount val="14"/>
                  <c:pt idx="0">
                    <c:v>0.3941632437</c:v>
                  </c:pt>
                  <c:pt idx="1">
                    <c:v>0.42561047660000001</c:v>
                  </c:pt>
                  <c:pt idx="2">
                    <c:v>0.4101067317</c:v>
                  </c:pt>
                  <c:pt idx="3">
                    <c:v>0.39172802810000001</c:v>
                  </c:pt>
                  <c:pt idx="4">
                    <c:v>0.39153680800000001</c:v>
                  </c:pt>
                  <c:pt idx="5">
                    <c:v>0.407347501</c:v>
                  </c:pt>
                  <c:pt idx="6">
                    <c:v>0.37102159950000002</c:v>
                  </c:pt>
                  <c:pt idx="7">
                    <c:v>0.47731606739999999</c:v>
                  </c:pt>
                  <c:pt idx="8">
                    <c:v>0.44064619020000001</c:v>
                  </c:pt>
                  <c:pt idx="9">
                    <c:v>0.49848134519999998</c:v>
                  </c:pt>
                  <c:pt idx="10">
                    <c:v>0.54442569139999997</c:v>
                  </c:pt>
                  <c:pt idx="11">
                    <c:v>0.43233945359999998</c:v>
                  </c:pt>
                  <c:pt idx="12">
                    <c:v>0.48692051060000002</c:v>
                  </c:pt>
                  <c:pt idx="13">
                    <c:v>0.47620950709999998</c:v>
                  </c:pt>
                </c:numCache>
              </c:numRef>
            </c:minus>
          </c:errBars>
          <c:xVal>
            <c:numRef>
              <c:f>boutn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!$D$2:$D$15</c:f>
              <c:numCache>
                <c:formatCode>General</c:formatCode>
                <c:ptCount val="14"/>
                <c:pt idx="0">
                  <c:v>11.053299492000001</c:v>
                </c:pt>
                <c:pt idx="1">
                  <c:v>12.574494949</c:v>
                </c:pt>
                <c:pt idx="2">
                  <c:v>11.4925</c:v>
                </c:pt>
                <c:pt idx="3">
                  <c:v>9.9625000000000004</c:v>
                </c:pt>
                <c:pt idx="4">
                  <c:v>10.828282828000001</c:v>
                </c:pt>
                <c:pt idx="5">
                  <c:v>12.358040201</c:v>
                </c:pt>
                <c:pt idx="6">
                  <c:v>12.626250000000001</c:v>
                </c:pt>
                <c:pt idx="7">
                  <c:v>15.121859296</c:v>
                </c:pt>
                <c:pt idx="8">
                  <c:v>12.236180904999999</c:v>
                </c:pt>
                <c:pt idx="9">
                  <c:v>12.138461538</c:v>
                </c:pt>
                <c:pt idx="10">
                  <c:v>12.88451087</c:v>
                </c:pt>
                <c:pt idx="11">
                  <c:v>11.039473684000001</c:v>
                </c:pt>
                <c:pt idx="12">
                  <c:v>11.342032967</c:v>
                </c:pt>
                <c:pt idx="13">
                  <c:v>12.908108108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boutn!$E$1</c:f>
              <c:strCache>
                <c:ptCount val="1"/>
                <c:pt idx="0">
                  <c:v>L1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utn!$N$2:$N$15</c:f>
                <c:numCache>
                  <c:formatCode>General</c:formatCode>
                  <c:ptCount val="14"/>
                  <c:pt idx="0">
                    <c:v>0.41498648069999999</c:v>
                  </c:pt>
                  <c:pt idx="1">
                    <c:v>0.46376833070000001</c:v>
                  </c:pt>
                  <c:pt idx="2">
                    <c:v>0.45505254560000002</c:v>
                  </c:pt>
                  <c:pt idx="3">
                    <c:v>0.4942822006</c:v>
                  </c:pt>
                  <c:pt idx="4">
                    <c:v>0.45499747499999998</c:v>
                  </c:pt>
                  <c:pt idx="5">
                    <c:v>0.29616627470000001</c:v>
                  </c:pt>
                  <c:pt idx="6">
                    <c:v>0.42656852350000002</c:v>
                  </c:pt>
                  <c:pt idx="7">
                    <c:v>0.48560879080000002</c:v>
                  </c:pt>
                  <c:pt idx="8">
                    <c:v>0.34276640920000001</c:v>
                  </c:pt>
                  <c:pt idx="9">
                    <c:v>0.32015256530000002</c:v>
                  </c:pt>
                  <c:pt idx="10">
                    <c:v>0.27468017709999998</c:v>
                  </c:pt>
                  <c:pt idx="11">
                    <c:v>0.30706836720000003</c:v>
                  </c:pt>
                  <c:pt idx="12">
                    <c:v>0.34611695749999999</c:v>
                  </c:pt>
                  <c:pt idx="13">
                    <c:v>0.37672151510000002</c:v>
                  </c:pt>
                </c:numCache>
              </c:numRef>
            </c:plus>
            <c:minus>
              <c:numRef>
                <c:f>boutn!$N$2:$N$15</c:f>
                <c:numCache>
                  <c:formatCode>General</c:formatCode>
                  <c:ptCount val="14"/>
                  <c:pt idx="0">
                    <c:v>0.41498648069999999</c:v>
                  </c:pt>
                  <c:pt idx="1">
                    <c:v>0.46376833070000001</c:v>
                  </c:pt>
                  <c:pt idx="2">
                    <c:v>0.45505254560000002</c:v>
                  </c:pt>
                  <c:pt idx="3">
                    <c:v>0.4942822006</c:v>
                  </c:pt>
                  <c:pt idx="4">
                    <c:v>0.45499747499999998</c:v>
                  </c:pt>
                  <c:pt idx="5">
                    <c:v>0.29616627470000001</c:v>
                  </c:pt>
                  <c:pt idx="6">
                    <c:v>0.42656852350000002</c:v>
                  </c:pt>
                  <c:pt idx="7">
                    <c:v>0.48560879080000002</c:v>
                  </c:pt>
                  <c:pt idx="8">
                    <c:v>0.34276640920000001</c:v>
                  </c:pt>
                  <c:pt idx="9">
                    <c:v>0.32015256530000002</c:v>
                  </c:pt>
                  <c:pt idx="10">
                    <c:v>0.27468017709999998</c:v>
                  </c:pt>
                  <c:pt idx="11">
                    <c:v>0.30706836720000003</c:v>
                  </c:pt>
                  <c:pt idx="12">
                    <c:v>0.34611695749999999</c:v>
                  </c:pt>
                  <c:pt idx="13">
                    <c:v>0.37672151510000002</c:v>
                  </c:pt>
                </c:numCache>
              </c:numRef>
            </c:minus>
          </c:errBars>
          <c:xVal>
            <c:numRef>
              <c:f>boutn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!$E$2:$E$15</c:f>
              <c:numCache>
                <c:formatCode>General</c:formatCode>
                <c:ptCount val="14"/>
                <c:pt idx="0">
                  <c:v>12.286163522000001</c:v>
                </c:pt>
                <c:pt idx="1">
                  <c:v>12.345052083000001</c:v>
                </c:pt>
                <c:pt idx="2">
                  <c:v>10.549242423999999</c:v>
                </c:pt>
                <c:pt idx="3">
                  <c:v>10.542091836999999</c:v>
                </c:pt>
                <c:pt idx="4">
                  <c:v>8.8535353534999999</c:v>
                </c:pt>
                <c:pt idx="5">
                  <c:v>6.0927835051999999</c:v>
                </c:pt>
                <c:pt idx="6">
                  <c:v>7.1459390863000003</c:v>
                </c:pt>
                <c:pt idx="7">
                  <c:v>8.0165816326999995</c:v>
                </c:pt>
                <c:pt idx="8">
                  <c:v>5.4437499999999996</c:v>
                </c:pt>
                <c:pt idx="9">
                  <c:v>5.0864361701999998</c:v>
                </c:pt>
                <c:pt idx="10">
                  <c:v>4.2847593582999997</c:v>
                </c:pt>
                <c:pt idx="11">
                  <c:v>3.7373188406</c:v>
                </c:pt>
                <c:pt idx="12">
                  <c:v>4.3953488372000002</c:v>
                </c:pt>
                <c:pt idx="13">
                  <c:v>5.5588235293999997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boutn!$F$1</c:f>
              <c:strCache>
                <c:ptCount val="1"/>
                <c:pt idx="0">
                  <c:v>L2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triang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utn!$O$2:$O$15</c:f>
                <c:numCache>
                  <c:formatCode>General</c:formatCode>
                  <c:ptCount val="14"/>
                  <c:pt idx="0">
                    <c:v>0.45348148589999998</c:v>
                  </c:pt>
                  <c:pt idx="1">
                    <c:v>0.45842581430000001</c:v>
                  </c:pt>
                  <c:pt idx="2">
                    <c:v>0.48900048889999997</c:v>
                  </c:pt>
                  <c:pt idx="3">
                    <c:v>0.36315093079999999</c:v>
                  </c:pt>
                  <c:pt idx="4">
                    <c:v>0.3217555312</c:v>
                  </c:pt>
                  <c:pt idx="5">
                    <c:v>0.34154443960000003</c:v>
                  </c:pt>
                  <c:pt idx="6">
                    <c:v>0.33794139899999998</c:v>
                  </c:pt>
                  <c:pt idx="7">
                    <c:v>0.47606678190000001</c:v>
                  </c:pt>
                  <c:pt idx="8">
                    <c:v>0.38210857920000002</c:v>
                  </c:pt>
                  <c:pt idx="9">
                    <c:v>0.3456947279</c:v>
                  </c:pt>
                  <c:pt idx="10">
                    <c:v>0.3614851154</c:v>
                  </c:pt>
                  <c:pt idx="11">
                    <c:v>0.33199089840000001</c:v>
                  </c:pt>
                  <c:pt idx="12">
                    <c:v>0.44415023949999999</c:v>
                  </c:pt>
                  <c:pt idx="13">
                    <c:v>0.41345272579999998</c:v>
                  </c:pt>
                </c:numCache>
              </c:numRef>
            </c:plus>
            <c:minus>
              <c:numRef>
                <c:f>boutn!$O$2:$O$15</c:f>
                <c:numCache>
                  <c:formatCode>General</c:formatCode>
                  <c:ptCount val="14"/>
                  <c:pt idx="0">
                    <c:v>0.45348148589999998</c:v>
                  </c:pt>
                  <c:pt idx="1">
                    <c:v>0.45842581430000001</c:v>
                  </c:pt>
                  <c:pt idx="2">
                    <c:v>0.48900048889999997</c:v>
                  </c:pt>
                  <c:pt idx="3">
                    <c:v>0.36315093079999999</c:v>
                  </c:pt>
                  <c:pt idx="4">
                    <c:v>0.3217555312</c:v>
                  </c:pt>
                  <c:pt idx="5">
                    <c:v>0.34154443960000003</c:v>
                  </c:pt>
                  <c:pt idx="6">
                    <c:v>0.33794139899999998</c:v>
                  </c:pt>
                  <c:pt idx="7">
                    <c:v>0.47606678190000001</c:v>
                  </c:pt>
                  <c:pt idx="8">
                    <c:v>0.38210857920000002</c:v>
                  </c:pt>
                  <c:pt idx="9">
                    <c:v>0.3456947279</c:v>
                  </c:pt>
                  <c:pt idx="10">
                    <c:v>0.3614851154</c:v>
                  </c:pt>
                  <c:pt idx="11">
                    <c:v>0.33199089840000001</c:v>
                  </c:pt>
                  <c:pt idx="12">
                    <c:v>0.44415023949999999</c:v>
                  </c:pt>
                  <c:pt idx="13">
                    <c:v>0.41345272579999998</c:v>
                  </c:pt>
                </c:numCache>
              </c:numRef>
            </c:minus>
          </c:errBars>
          <c:xVal>
            <c:numRef>
              <c:f>boutn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!$F$2:$F$15</c:f>
              <c:numCache>
                <c:formatCode>General</c:formatCode>
                <c:ptCount val="14"/>
                <c:pt idx="0">
                  <c:v>13.287688442</c:v>
                </c:pt>
                <c:pt idx="1">
                  <c:v>11.909547739000001</c:v>
                </c:pt>
                <c:pt idx="2">
                  <c:v>11.070153060999999</c:v>
                </c:pt>
                <c:pt idx="3">
                  <c:v>7.9720812182999996</c:v>
                </c:pt>
                <c:pt idx="4">
                  <c:v>7.5050761421000001</c:v>
                </c:pt>
                <c:pt idx="5">
                  <c:v>8.1967005075999992</c:v>
                </c:pt>
                <c:pt idx="6">
                  <c:v>9.8462499999999995</c:v>
                </c:pt>
                <c:pt idx="7">
                  <c:v>10.456030151</c:v>
                </c:pt>
                <c:pt idx="8">
                  <c:v>6.1439393939000002</c:v>
                </c:pt>
                <c:pt idx="9">
                  <c:v>7.2399497487</c:v>
                </c:pt>
                <c:pt idx="10">
                  <c:v>6.3578947367999996</c:v>
                </c:pt>
                <c:pt idx="11">
                  <c:v>6.1717171717000001</c:v>
                </c:pt>
                <c:pt idx="12">
                  <c:v>8.7797927461</c:v>
                </c:pt>
                <c:pt idx="13">
                  <c:v>6.4749999999999996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boutn!$G$1</c:f>
              <c:strCache>
                <c:ptCount val="1"/>
                <c:pt idx="0">
                  <c:v>S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utn!$P$2:$P$15</c:f>
                <c:numCache>
                  <c:formatCode>General</c:formatCode>
                  <c:ptCount val="14"/>
                  <c:pt idx="0">
                    <c:v>0.4725209849</c:v>
                  </c:pt>
                  <c:pt idx="1">
                    <c:v>0.41033096870000002</c:v>
                  </c:pt>
                  <c:pt idx="2">
                    <c:v>0.40719037530000002</c:v>
                  </c:pt>
                  <c:pt idx="3">
                    <c:v>0.41780651200000002</c:v>
                  </c:pt>
                  <c:pt idx="4">
                    <c:v>0.38645299490000001</c:v>
                  </c:pt>
                  <c:pt idx="5">
                    <c:v>0.43392447779999999</c:v>
                  </c:pt>
                  <c:pt idx="6">
                    <c:v>0.39547203910000001</c:v>
                  </c:pt>
                  <c:pt idx="7">
                    <c:v>0.43746868090000002</c:v>
                  </c:pt>
                  <c:pt idx="8">
                    <c:v>0.32979016049999998</c:v>
                  </c:pt>
                  <c:pt idx="9">
                    <c:v>0.4489414592</c:v>
                  </c:pt>
                  <c:pt idx="10">
                    <c:v>0.37497812009999998</c:v>
                  </c:pt>
                  <c:pt idx="11">
                    <c:v>0.46959346320000001</c:v>
                  </c:pt>
                  <c:pt idx="12">
                    <c:v>0.57984658629999997</c:v>
                  </c:pt>
                  <c:pt idx="13">
                    <c:v>0.57677183470000004</c:v>
                  </c:pt>
                </c:numCache>
              </c:numRef>
            </c:plus>
            <c:minus>
              <c:numRef>
                <c:f>boutn!$P$2:$P$15</c:f>
                <c:numCache>
                  <c:formatCode>General</c:formatCode>
                  <c:ptCount val="14"/>
                  <c:pt idx="0">
                    <c:v>0.4725209849</c:v>
                  </c:pt>
                  <c:pt idx="1">
                    <c:v>0.41033096870000002</c:v>
                  </c:pt>
                  <c:pt idx="2">
                    <c:v>0.40719037530000002</c:v>
                  </c:pt>
                  <c:pt idx="3">
                    <c:v>0.41780651200000002</c:v>
                  </c:pt>
                  <c:pt idx="4">
                    <c:v>0.38645299490000001</c:v>
                  </c:pt>
                  <c:pt idx="5">
                    <c:v>0.43392447779999999</c:v>
                  </c:pt>
                  <c:pt idx="6">
                    <c:v>0.39547203910000001</c:v>
                  </c:pt>
                  <c:pt idx="7">
                    <c:v>0.43746868090000002</c:v>
                  </c:pt>
                  <c:pt idx="8">
                    <c:v>0.32979016049999998</c:v>
                  </c:pt>
                  <c:pt idx="9">
                    <c:v>0.4489414592</c:v>
                  </c:pt>
                  <c:pt idx="10">
                    <c:v>0.37497812009999998</c:v>
                  </c:pt>
                  <c:pt idx="11">
                    <c:v>0.46959346320000001</c:v>
                  </c:pt>
                  <c:pt idx="12">
                    <c:v>0.57984658629999997</c:v>
                  </c:pt>
                  <c:pt idx="13">
                    <c:v>0.57677183470000004</c:v>
                  </c:pt>
                </c:numCache>
              </c:numRef>
            </c:minus>
          </c:errBars>
          <c:xVal>
            <c:numRef>
              <c:f>boutn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!$G$2:$G$15</c:f>
              <c:numCache>
                <c:formatCode>General</c:formatCode>
                <c:ptCount val="14"/>
                <c:pt idx="0">
                  <c:v>10.912121212000001</c:v>
                </c:pt>
                <c:pt idx="1">
                  <c:v>12.22361809</c:v>
                </c:pt>
                <c:pt idx="2">
                  <c:v>11.480769231</c:v>
                </c:pt>
                <c:pt idx="3">
                  <c:v>10.630653265999999</c:v>
                </c:pt>
                <c:pt idx="4">
                  <c:v>9.5778061224000002</c:v>
                </c:pt>
                <c:pt idx="5">
                  <c:v>8.9659090909000003</c:v>
                </c:pt>
                <c:pt idx="6">
                  <c:v>8.3635204081999994</c:v>
                </c:pt>
                <c:pt idx="7">
                  <c:v>6.1931818182000002</c:v>
                </c:pt>
                <c:pt idx="8">
                  <c:v>4.6537499999999996</c:v>
                </c:pt>
                <c:pt idx="9">
                  <c:v>7.6964285714000003</c:v>
                </c:pt>
                <c:pt idx="10">
                  <c:v>6.3338323353000003</c:v>
                </c:pt>
                <c:pt idx="11">
                  <c:v>6.9557291667000003</c:v>
                </c:pt>
                <c:pt idx="12">
                  <c:v>7.0968468468000001</c:v>
                </c:pt>
                <c:pt idx="13">
                  <c:v>8.4950980392000002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boutn!$H$1</c:f>
              <c:strCache>
                <c:ptCount val="1"/>
                <c:pt idx="0">
                  <c:v>S2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boutn!$Q$2:$Q$15</c:f>
                <c:numCache>
                  <c:formatCode>General</c:formatCode>
                  <c:ptCount val="14"/>
                  <c:pt idx="0">
                    <c:v>0.44773826550000001</c:v>
                  </c:pt>
                  <c:pt idx="1">
                    <c:v>0.43709643679999999</c:v>
                  </c:pt>
                  <c:pt idx="2">
                    <c:v>0.42337087070000001</c:v>
                  </c:pt>
                  <c:pt idx="3">
                    <c:v>0.42611405460000001</c:v>
                  </c:pt>
                  <c:pt idx="4">
                    <c:v>0.35761312670000001</c:v>
                  </c:pt>
                  <c:pt idx="5">
                    <c:v>0.38046534189999998</c:v>
                  </c:pt>
                  <c:pt idx="6">
                    <c:v>0.38718134370000001</c:v>
                  </c:pt>
                  <c:pt idx="7">
                    <c:v>0.43903477279999997</c:v>
                  </c:pt>
                  <c:pt idx="8">
                    <c:v>0.44615164219999998</c:v>
                  </c:pt>
                  <c:pt idx="9">
                    <c:v>0.37389329020000001</c:v>
                  </c:pt>
                  <c:pt idx="10">
                    <c:v>0.48841027970000001</c:v>
                  </c:pt>
                  <c:pt idx="11">
                    <c:v>0.41603740430000002</c:v>
                  </c:pt>
                  <c:pt idx="12">
                    <c:v>0.3710948583</c:v>
                  </c:pt>
                  <c:pt idx="13">
                    <c:v>0.35991381169999997</c:v>
                  </c:pt>
                </c:numCache>
              </c:numRef>
            </c:plus>
            <c:minus>
              <c:numRef>
                <c:f>boutn!$Q$2:$Q$15</c:f>
                <c:numCache>
                  <c:formatCode>General</c:formatCode>
                  <c:ptCount val="14"/>
                  <c:pt idx="0">
                    <c:v>0.44773826550000001</c:v>
                  </c:pt>
                  <c:pt idx="1">
                    <c:v>0.43709643679999999</c:v>
                  </c:pt>
                  <c:pt idx="2">
                    <c:v>0.42337087070000001</c:v>
                  </c:pt>
                  <c:pt idx="3">
                    <c:v>0.42611405460000001</c:v>
                  </c:pt>
                  <c:pt idx="4">
                    <c:v>0.35761312670000001</c:v>
                  </c:pt>
                  <c:pt idx="5">
                    <c:v>0.38046534189999998</c:v>
                  </c:pt>
                  <c:pt idx="6">
                    <c:v>0.38718134370000001</c:v>
                  </c:pt>
                  <c:pt idx="7">
                    <c:v>0.43903477279999997</c:v>
                  </c:pt>
                  <c:pt idx="8">
                    <c:v>0.44615164219999998</c:v>
                  </c:pt>
                  <c:pt idx="9">
                    <c:v>0.37389329020000001</c:v>
                  </c:pt>
                  <c:pt idx="10">
                    <c:v>0.48841027970000001</c:v>
                  </c:pt>
                  <c:pt idx="11">
                    <c:v>0.41603740430000002</c:v>
                  </c:pt>
                  <c:pt idx="12">
                    <c:v>0.3710948583</c:v>
                  </c:pt>
                  <c:pt idx="13">
                    <c:v>0.35991381169999997</c:v>
                  </c:pt>
                </c:numCache>
              </c:numRef>
            </c:minus>
          </c:errBars>
          <c:xVal>
            <c:numRef>
              <c:f>boutn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boutn!$H$2:$H$15</c:f>
              <c:numCache>
                <c:formatCode>General</c:formatCode>
                <c:ptCount val="14"/>
                <c:pt idx="0">
                  <c:v>12.060301508</c:v>
                </c:pt>
                <c:pt idx="1">
                  <c:v>15.623076922999999</c:v>
                </c:pt>
                <c:pt idx="2">
                  <c:v>12.13125</c:v>
                </c:pt>
                <c:pt idx="3">
                  <c:v>10.771356784</c:v>
                </c:pt>
                <c:pt idx="4">
                  <c:v>11.516331658</c:v>
                </c:pt>
                <c:pt idx="5">
                  <c:v>10.559644670000001</c:v>
                </c:pt>
                <c:pt idx="6">
                  <c:v>9.5100502512999991</c:v>
                </c:pt>
                <c:pt idx="7">
                  <c:v>8.6557788944999992</c:v>
                </c:pt>
                <c:pt idx="8">
                  <c:v>6.8266331657999997</c:v>
                </c:pt>
                <c:pt idx="9">
                  <c:v>6.9347826087</c:v>
                </c:pt>
                <c:pt idx="10">
                  <c:v>8.6287313433000001</c:v>
                </c:pt>
                <c:pt idx="11">
                  <c:v>6.1006097560999999</c:v>
                </c:pt>
                <c:pt idx="12">
                  <c:v>4.6777777778000003</c:v>
                </c:pt>
                <c:pt idx="13">
                  <c:v>4.637658227800000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157952"/>
        <c:axId val="128180224"/>
      </c:scatterChart>
      <c:valAx>
        <c:axId val="128157952"/>
        <c:scaling>
          <c:orientation val="minMax"/>
          <c:max val="13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180224"/>
        <c:crosses val="autoZero"/>
        <c:crossBetween val="midCat"/>
        <c:majorUnit val="2"/>
      </c:valAx>
      <c:valAx>
        <c:axId val="128180224"/>
        <c:scaling>
          <c:orientation val="minMax"/>
          <c:max val="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157952"/>
        <c:crosses val="autoZero"/>
        <c:crossBetween val="midCat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wakeact!$C$1</c:f>
              <c:strCache>
                <c:ptCount val="1"/>
                <c:pt idx="0">
                  <c:v>C1</c:v>
                </c:pt>
              </c:strCache>
            </c:strRef>
          </c:tx>
          <c:spPr>
            <a:ln w="190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keact!$L$2:$L$15</c:f>
                <c:numCache>
                  <c:formatCode>General</c:formatCode>
                  <c:ptCount val="14"/>
                  <c:pt idx="0">
                    <c:v>2.8430731099999999E-2</c:v>
                  </c:pt>
                  <c:pt idx="1">
                    <c:v>2.72498581E-2</c:v>
                  </c:pt>
                  <c:pt idx="2">
                    <c:v>3.1617643899999999E-2</c:v>
                  </c:pt>
                  <c:pt idx="3">
                    <c:v>4.0515537999999997E-2</c:v>
                  </c:pt>
                  <c:pt idx="4">
                    <c:v>3.9653463200000003E-2</c:v>
                  </c:pt>
                  <c:pt idx="5">
                    <c:v>3.7432011799999998E-2</c:v>
                  </c:pt>
                  <c:pt idx="6">
                    <c:v>4.4211141099999997E-2</c:v>
                  </c:pt>
                  <c:pt idx="7">
                    <c:v>3.7548549299999998E-2</c:v>
                  </c:pt>
                  <c:pt idx="8">
                    <c:v>5.4354336099999997E-2</c:v>
                  </c:pt>
                  <c:pt idx="9">
                    <c:v>3.08662333E-2</c:v>
                  </c:pt>
                  <c:pt idx="10">
                    <c:v>3.8733770799999998E-2</c:v>
                  </c:pt>
                  <c:pt idx="11">
                    <c:v>3.4618736099999999E-2</c:v>
                  </c:pt>
                  <c:pt idx="12">
                    <c:v>3.6396195300000003E-2</c:v>
                  </c:pt>
                  <c:pt idx="13">
                    <c:v>3.5892502100000001E-2</c:v>
                  </c:pt>
                </c:numCache>
              </c:numRef>
            </c:plus>
            <c:minus>
              <c:numRef>
                <c:f>wakeact!$L$2:$L$15</c:f>
                <c:numCache>
                  <c:formatCode>General</c:formatCode>
                  <c:ptCount val="14"/>
                  <c:pt idx="0">
                    <c:v>2.8430731099999999E-2</c:v>
                  </c:pt>
                  <c:pt idx="1">
                    <c:v>2.72498581E-2</c:v>
                  </c:pt>
                  <c:pt idx="2">
                    <c:v>3.1617643899999999E-2</c:v>
                  </c:pt>
                  <c:pt idx="3">
                    <c:v>4.0515537999999997E-2</c:v>
                  </c:pt>
                  <c:pt idx="4">
                    <c:v>3.9653463200000003E-2</c:v>
                  </c:pt>
                  <c:pt idx="5">
                    <c:v>3.7432011799999998E-2</c:v>
                  </c:pt>
                  <c:pt idx="6">
                    <c:v>4.4211141099999997E-2</c:v>
                  </c:pt>
                  <c:pt idx="7">
                    <c:v>3.7548549299999998E-2</c:v>
                  </c:pt>
                  <c:pt idx="8">
                    <c:v>5.4354336099999997E-2</c:v>
                  </c:pt>
                  <c:pt idx="9">
                    <c:v>3.08662333E-2</c:v>
                  </c:pt>
                  <c:pt idx="10">
                    <c:v>3.8733770799999998E-2</c:v>
                  </c:pt>
                  <c:pt idx="11">
                    <c:v>3.4618736099999999E-2</c:v>
                  </c:pt>
                  <c:pt idx="12">
                    <c:v>3.6396195300000003E-2</c:v>
                  </c:pt>
                  <c:pt idx="13">
                    <c:v>3.5892502100000001E-2</c:v>
                  </c:pt>
                </c:numCache>
              </c:numRef>
            </c:minus>
          </c:errBars>
          <c:xVal>
            <c:numRef>
              <c:f>wakeact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eact!$C$2:$C$15</c:f>
              <c:numCache>
                <c:formatCode>General</c:formatCode>
                <c:ptCount val="14"/>
                <c:pt idx="0">
                  <c:v>1.5569979726000001</c:v>
                </c:pt>
                <c:pt idx="1">
                  <c:v>1.5365041453999999</c:v>
                </c:pt>
                <c:pt idx="2">
                  <c:v>1.5850736000000001</c:v>
                </c:pt>
                <c:pt idx="3">
                  <c:v>1.8056907250000001</c:v>
                </c:pt>
                <c:pt idx="4">
                  <c:v>1.8499743593</c:v>
                </c:pt>
                <c:pt idx="5">
                  <c:v>1.802787675</c:v>
                </c:pt>
                <c:pt idx="6">
                  <c:v>1.7808561168000001</c:v>
                </c:pt>
                <c:pt idx="7">
                  <c:v>1.7105982286000001</c:v>
                </c:pt>
                <c:pt idx="8">
                  <c:v>1.8698730374999999</c:v>
                </c:pt>
                <c:pt idx="9">
                  <c:v>1.5705528756</c:v>
                </c:pt>
                <c:pt idx="10">
                  <c:v>1.5750387712</c:v>
                </c:pt>
                <c:pt idx="11">
                  <c:v>1.6323420833</c:v>
                </c:pt>
                <c:pt idx="12">
                  <c:v>1.6877103916</c:v>
                </c:pt>
                <c:pt idx="13">
                  <c:v>1.704836521700000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wakeact!$D$1</c:f>
              <c:strCache>
                <c:ptCount val="1"/>
                <c:pt idx="0">
                  <c:v>C2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keact!$M$2:$M$15</c:f>
                <c:numCache>
                  <c:formatCode>General</c:formatCode>
                  <c:ptCount val="14"/>
                  <c:pt idx="0">
                    <c:v>2.98115831E-2</c:v>
                  </c:pt>
                  <c:pt idx="1">
                    <c:v>3.0409465300000001E-2</c:v>
                  </c:pt>
                  <c:pt idx="2">
                    <c:v>3.00095113E-2</c:v>
                  </c:pt>
                  <c:pt idx="3">
                    <c:v>3.6513992100000003E-2</c:v>
                  </c:pt>
                  <c:pt idx="4">
                    <c:v>3.52404272E-2</c:v>
                  </c:pt>
                  <c:pt idx="5">
                    <c:v>2.7664448599999999E-2</c:v>
                  </c:pt>
                  <c:pt idx="6">
                    <c:v>3.3496160599999998E-2</c:v>
                  </c:pt>
                  <c:pt idx="7">
                    <c:v>3.8046053199999999E-2</c:v>
                  </c:pt>
                  <c:pt idx="8">
                    <c:v>3.1391335300000003E-2</c:v>
                  </c:pt>
                  <c:pt idx="9">
                    <c:v>3.2146218599999998E-2</c:v>
                  </c:pt>
                  <c:pt idx="10">
                    <c:v>4.3603051499999997E-2</c:v>
                  </c:pt>
                  <c:pt idx="11">
                    <c:v>3.77870373E-2</c:v>
                  </c:pt>
                  <c:pt idx="12">
                    <c:v>4.28354575E-2</c:v>
                  </c:pt>
                  <c:pt idx="13">
                    <c:v>3.2743964200000003E-2</c:v>
                  </c:pt>
                </c:numCache>
              </c:numRef>
            </c:plus>
            <c:minus>
              <c:numRef>
                <c:f>wakeact!$M$2:$M$15</c:f>
                <c:numCache>
                  <c:formatCode>General</c:formatCode>
                  <c:ptCount val="14"/>
                  <c:pt idx="0">
                    <c:v>2.98115831E-2</c:v>
                  </c:pt>
                  <c:pt idx="1">
                    <c:v>3.0409465300000001E-2</c:v>
                  </c:pt>
                  <c:pt idx="2">
                    <c:v>3.00095113E-2</c:v>
                  </c:pt>
                  <c:pt idx="3">
                    <c:v>3.6513992100000003E-2</c:v>
                  </c:pt>
                  <c:pt idx="4">
                    <c:v>3.52404272E-2</c:v>
                  </c:pt>
                  <c:pt idx="5">
                    <c:v>2.7664448599999999E-2</c:v>
                  </c:pt>
                  <c:pt idx="6">
                    <c:v>3.3496160599999998E-2</c:v>
                  </c:pt>
                  <c:pt idx="7">
                    <c:v>3.8046053199999999E-2</c:v>
                  </c:pt>
                  <c:pt idx="8">
                    <c:v>3.1391335300000003E-2</c:v>
                  </c:pt>
                  <c:pt idx="9">
                    <c:v>3.2146218599999998E-2</c:v>
                  </c:pt>
                  <c:pt idx="10">
                    <c:v>4.3603051499999997E-2</c:v>
                  </c:pt>
                  <c:pt idx="11">
                    <c:v>3.77870373E-2</c:v>
                  </c:pt>
                  <c:pt idx="12">
                    <c:v>4.28354575E-2</c:v>
                  </c:pt>
                  <c:pt idx="13">
                    <c:v>3.2743964200000003E-2</c:v>
                  </c:pt>
                </c:numCache>
              </c:numRef>
            </c:minus>
          </c:errBars>
          <c:xVal>
            <c:numRef>
              <c:f>wakeact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eact!$D$2:$D$15</c:f>
              <c:numCache>
                <c:formatCode>General</c:formatCode>
                <c:ptCount val="14"/>
                <c:pt idx="0">
                  <c:v>1.7038843781999999</c:v>
                </c:pt>
                <c:pt idx="1">
                  <c:v>1.6419131566</c:v>
                </c:pt>
                <c:pt idx="2">
                  <c:v>1.685909825</c:v>
                </c:pt>
                <c:pt idx="3">
                  <c:v>1.6363173124999999</c:v>
                </c:pt>
                <c:pt idx="4">
                  <c:v>1.7127628409</c:v>
                </c:pt>
                <c:pt idx="5">
                  <c:v>1.5845017084999999</c:v>
                </c:pt>
                <c:pt idx="6">
                  <c:v>1.8158720749999999</c:v>
                </c:pt>
                <c:pt idx="7">
                  <c:v>1.6693128518</c:v>
                </c:pt>
                <c:pt idx="8">
                  <c:v>1.7174750879</c:v>
                </c:pt>
                <c:pt idx="9">
                  <c:v>1.4769731282</c:v>
                </c:pt>
                <c:pt idx="10">
                  <c:v>1.4563695109000001</c:v>
                </c:pt>
                <c:pt idx="11">
                  <c:v>1.6542458684000001</c:v>
                </c:pt>
                <c:pt idx="12">
                  <c:v>1.766993228</c:v>
                </c:pt>
                <c:pt idx="13">
                  <c:v>1.5604168108000001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wakeact!$E$1</c:f>
              <c:strCache>
                <c:ptCount val="1"/>
                <c:pt idx="0">
                  <c:v>L1</c:v>
                </c:pt>
              </c:strCache>
            </c:strRef>
          </c:tx>
          <c:spPr>
            <a:ln w="19050">
              <a:solidFill>
                <a:srgbClr val="0070C0"/>
              </a:solidFill>
            </a:ln>
          </c:spPr>
          <c:marker>
            <c:symbol val="triangle"/>
            <c:size val="4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keact!$N$2:$N$15</c:f>
                <c:numCache>
                  <c:formatCode>General</c:formatCode>
                  <c:ptCount val="14"/>
                  <c:pt idx="0">
                    <c:v>2.7759138100000001E-2</c:v>
                  </c:pt>
                  <c:pt idx="1">
                    <c:v>3.8135998900000002E-2</c:v>
                  </c:pt>
                  <c:pt idx="2">
                    <c:v>2.9900564899999999E-2</c:v>
                  </c:pt>
                  <c:pt idx="3">
                    <c:v>3.32711308E-2</c:v>
                  </c:pt>
                  <c:pt idx="4">
                    <c:v>3.6791626399999999E-2</c:v>
                  </c:pt>
                  <c:pt idx="5">
                    <c:v>3.2690857800000001E-2</c:v>
                  </c:pt>
                  <c:pt idx="6">
                    <c:v>4.2336538999999999E-2</c:v>
                  </c:pt>
                  <c:pt idx="7">
                    <c:v>3.9033709600000001E-2</c:v>
                  </c:pt>
                  <c:pt idx="8">
                    <c:v>4.6470137799999998E-2</c:v>
                  </c:pt>
                  <c:pt idx="9">
                    <c:v>3.7564274199999997E-2</c:v>
                  </c:pt>
                  <c:pt idx="10">
                    <c:v>4.8572063800000002E-2</c:v>
                  </c:pt>
                  <c:pt idx="11">
                    <c:v>0.1727853053</c:v>
                  </c:pt>
                  <c:pt idx="12">
                    <c:v>6.7821570499999997E-2</c:v>
                  </c:pt>
                  <c:pt idx="13">
                    <c:v>4.5925994300000002E-2</c:v>
                  </c:pt>
                </c:numCache>
              </c:numRef>
            </c:plus>
            <c:minus>
              <c:numRef>
                <c:f>wakeact!$N$2:$N$15</c:f>
                <c:numCache>
                  <c:formatCode>General</c:formatCode>
                  <c:ptCount val="14"/>
                  <c:pt idx="0">
                    <c:v>2.7759138100000001E-2</c:v>
                  </c:pt>
                  <c:pt idx="1">
                    <c:v>3.8135998900000002E-2</c:v>
                  </c:pt>
                  <c:pt idx="2">
                    <c:v>2.9900564899999999E-2</c:v>
                  </c:pt>
                  <c:pt idx="3">
                    <c:v>3.32711308E-2</c:v>
                  </c:pt>
                  <c:pt idx="4">
                    <c:v>3.6791626399999999E-2</c:v>
                  </c:pt>
                  <c:pt idx="5">
                    <c:v>3.2690857800000001E-2</c:v>
                  </c:pt>
                  <c:pt idx="6">
                    <c:v>4.2336538999999999E-2</c:v>
                  </c:pt>
                  <c:pt idx="7">
                    <c:v>3.9033709600000001E-2</c:v>
                  </c:pt>
                  <c:pt idx="8">
                    <c:v>4.6470137799999998E-2</c:v>
                  </c:pt>
                  <c:pt idx="9">
                    <c:v>3.7564274199999997E-2</c:v>
                  </c:pt>
                  <c:pt idx="10">
                    <c:v>4.8572063800000002E-2</c:v>
                  </c:pt>
                  <c:pt idx="11">
                    <c:v>0.1727853053</c:v>
                  </c:pt>
                  <c:pt idx="12">
                    <c:v>6.7821570499999997E-2</c:v>
                  </c:pt>
                  <c:pt idx="13">
                    <c:v>4.5925994300000002E-2</c:v>
                  </c:pt>
                </c:numCache>
              </c:numRef>
            </c:minus>
          </c:errBars>
          <c:xVal>
            <c:numRef>
              <c:f>wakeact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eact!$E$2:$E$15</c:f>
              <c:numCache>
                <c:formatCode>General</c:formatCode>
                <c:ptCount val="14"/>
                <c:pt idx="0">
                  <c:v>1.5011732547000001</c:v>
                </c:pt>
                <c:pt idx="1">
                  <c:v>1.7468717577999999</c:v>
                </c:pt>
                <c:pt idx="2">
                  <c:v>1.6550929798</c:v>
                </c:pt>
                <c:pt idx="3">
                  <c:v>1.7484185714</c:v>
                </c:pt>
                <c:pt idx="4">
                  <c:v>1.8182048737000001</c:v>
                </c:pt>
                <c:pt idx="5">
                  <c:v>1.7624463272999999</c:v>
                </c:pt>
                <c:pt idx="6">
                  <c:v>1.7965667132000001</c:v>
                </c:pt>
                <c:pt idx="7">
                  <c:v>1.7485115434</c:v>
                </c:pt>
                <c:pt idx="8">
                  <c:v>1.7944139125</c:v>
                </c:pt>
                <c:pt idx="9">
                  <c:v>1.6935508909999999</c:v>
                </c:pt>
                <c:pt idx="10">
                  <c:v>1.7000032219000001</c:v>
                </c:pt>
                <c:pt idx="11">
                  <c:v>1.8009491304</c:v>
                </c:pt>
                <c:pt idx="12">
                  <c:v>1.8488586047</c:v>
                </c:pt>
                <c:pt idx="13">
                  <c:v>1.674188643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wakeact!$F$1</c:f>
              <c:strCache>
                <c:ptCount val="1"/>
                <c:pt idx="0">
                  <c:v>L2</c:v>
                </c:pt>
              </c:strCache>
            </c:strRef>
          </c:tx>
          <c:spPr>
            <a:ln w="19050">
              <a:solidFill>
                <a:srgbClr val="0000FF"/>
              </a:solidFill>
            </a:ln>
          </c:spPr>
          <c:marker>
            <c:symbol val="triang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keact!$O$2:$O$15</c:f>
                <c:numCache>
                  <c:formatCode>General</c:formatCode>
                  <c:ptCount val="14"/>
                  <c:pt idx="0">
                    <c:v>3.2622479699999998E-2</c:v>
                  </c:pt>
                  <c:pt idx="1">
                    <c:v>3.0806792E-2</c:v>
                  </c:pt>
                  <c:pt idx="2">
                    <c:v>3.5036475900000003E-2</c:v>
                  </c:pt>
                  <c:pt idx="3">
                    <c:v>3.4851032900000002E-2</c:v>
                  </c:pt>
                  <c:pt idx="4">
                    <c:v>3.9449250300000002E-2</c:v>
                  </c:pt>
                  <c:pt idx="5">
                    <c:v>3.7845479299999998E-2</c:v>
                  </c:pt>
                  <c:pt idx="6">
                    <c:v>3.7892219599999999E-2</c:v>
                  </c:pt>
                  <c:pt idx="7">
                    <c:v>3.30652424E-2</c:v>
                  </c:pt>
                  <c:pt idx="8">
                    <c:v>3.5879834800000003E-2</c:v>
                  </c:pt>
                  <c:pt idx="9">
                    <c:v>3.9602403199999997E-2</c:v>
                  </c:pt>
                  <c:pt idx="10">
                    <c:v>2.8296908199999998E-2</c:v>
                  </c:pt>
                  <c:pt idx="11">
                    <c:v>4.3523133499999998E-2</c:v>
                  </c:pt>
                  <c:pt idx="12">
                    <c:v>3.7522944400000001E-2</c:v>
                  </c:pt>
                  <c:pt idx="13">
                    <c:v>4.3650189499999999E-2</c:v>
                  </c:pt>
                </c:numCache>
              </c:numRef>
            </c:plus>
            <c:minus>
              <c:numRef>
                <c:f>wakeact!$O$2:$O$15</c:f>
                <c:numCache>
                  <c:formatCode>General</c:formatCode>
                  <c:ptCount val="14"/>
                  <c:pt idx="0">
                    <c:v>3.2622479699999998E-2</c:v>
                  </c:pt>
                  <c:pt idx="1">
                    <c:v>3.0806792E-2</c:v>
                  </c:pt>
                  <c:pt idx="2">
                    <c:v>3.5036475900000003E-2</c:v>
                  </c:pt>
                  <c:pt idx="3">
                    <c:v>3.4851032900000002E-2</c:v>
                  </c:pt>
                  <c:pt idx="4">
                    <c:v>3.9449250300000002E-2</c:v>
                  </c:pt>
                  <c:pt idx="5">
                    <c:v>3.7845479299999998E-2</c:v>
                  </c:pt>
                  <c:pt idx="6">
                    <c:v>3.7892219599999999E-2</c:v>
                  </c:pt>
                  <c:pt idx="7">
                    <c:v>3.30652424E-2</c:v>
                  </c:pt>
                  <c:pt idx="8">
                    <c:v>3.5879834800000003E-2</c:v>
                  </c:pt>
                  <c:pt idx="9">
                    <c:v>3.9602403199999997E-2</c:v>
                  </c:pt>
                  <c:pt idx="10">
                    <c:v>2.8296908199999998E-2</c:v>
                  </c:pt>
                  <c:pt idx="11">
                    <c:v>4.3523133499999998E-2</c:v>
                  </c:pt>
                  <c:pt idx="12">
                    <c:v>3.7522944400000001E-2</c:v>
                  </c:pt>
                  <c:pt idx="13">
                    <c:v>4.3650189499999999E-2</c:v>
                  </c:pt>
                </c:numCache>
              </c:numRef>
            </c:minus>
          </c:errBars>
          <c:xVal>
            <c:numRef>
              <c:f>wakeact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eact!$F$2:$F$15</c:f>
              <c:numCache>
                <c:formatCode>General</c:formatCode>
                <c:ptCount val="14"/>
                <c:pt idx="0">
                  <c:v>1.7236333417</c:v>
                </c:pt>
                <c:pt idx="1">
                  <c:v>1.6878699874</c:v>
                </c:pt>
                <c:pt idx="2">
                  <c:v>1.6602122959000001</c:v>
                </c:pt>
                <c:pt idx="3">
                  <c:v>1.7254154694999999</c:v>
                </c:pt>
                <c:pt idx="4">
                  <c:v>1.7725557614</c:v>
                </c:pt>
                <c:pt idx="5">
                  <c:v>1.7724698477</c:v>
                </c:pt>
                <c:pt idx="6">
                  <c:v>1.9213924499999999</c:v>
                </c:pt>
                <c:pt idx="7">
                  <c:v>1.6614795352</c:v>
                </c:pt>
                <c:pt idx="8">
                  <c:v>1.6107641035</c:v>
                </c:pt>
                <c:pt idx="9">
                  <c:v>1.5766369975000001</c:v>
                </c:pt>
                <c:pt idx="10">
                  <c:v>1.4503216447</c:v>
                </c:pt>
                <c:pt idx="11">
                  <c:v>1.5334371465000001</c:v>
                </c:pt>
                <c:pt idx="12">
                  <c:v>1.7314020207</c:v>
                </c:pt>
                <c:pt idx="13">
                  <c:v>1.6086388947000001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wakeact!$G$1</c:f>
              <c:strCache>
                <c:ptCount val="1"/>
                <c:pt idx="0">
                  <c:v>S1</c:v>
                </c:pt>
              </c:strCache>
            </c:strRef>
          </c:tx>
          <c:spPr>
            <a:ln w="19050">
              <a:solidFill>
                <a:srgbClr val="FF0000"/>
              </a:solidFill>
            </a:ln>
          </c:spPr>
          <c:marker>
            <c:symbol val="square"/>
            <c:size val="4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keact!$P$2:$P$15</c:f>
                <c:numCache>
                  <c:formatCode>General</c:formatCode>
                  <c:ptCount val="14"/>
                  <c:pt idx="0">
                    <c:v>2.30918913E-2</c:v>
                  </c:pt>
                  <c:pt idx="1">
                    <c:v>2.76380931E-2</c:v>
                  </c:pt>
                  <c:pt idx="2">
                    <c:v>2.4892048399999998E-2</c:v>
                  </c:pt>
                  <c:pt idx="3">
                    <c:v>4.0993792000000001E-2</c:v>
                  </c:pt>
                  <c:pt idx="4">
                    <c:v>4.4385060599999998E-2</c:v>
                  </c:pt>
                  <c:pt idx="5">
                    <c:v>3.3322201000000003E-2</c:v>
                  </c:pt>
                  <c:pt idx="6">
                    <c:v>4.4057110199999999E-2</c:v>
                  </c:pt>
                  <c:pt idx="7">
                    <c:v>3.8080773700000001E-2</c:v>
                  </c:pt>
                  <c:pt idx="8">
                    <c:v>3.5336485100000002E-2</c:v>
                  </c:pt>
                  <c:pt idx="9">
                    <c:v>3.63976367E-2</c:v>
                  </c:pt>
                  <c:pt idx="10">
                    <c:v>3.63206955E-2</c:v>
                  </c:pt>
                  <c:pt idx="11">
                    <c:v>4.76932339E-2</c:v>
                  </c:pt>
                  <c:pt idx="12">
                    <c:v>4.1401742599999999E-2</c:v>
                  </c:pt>
                  <c:pt idx="13">
                    <c:v>5.2477910900000001E-2</c:v>
                  </c:pt>
                </c:numCache>
              </c:numRef>
            </c:plus>
            <c:minus>
              <c:numRef>
                <c:f>wakeact!$P$2:$P$15</c:f>
                <c:numCache>
                  <c:formatCode>General</c:formatCode>
                  <c:ptCount val="14"/>
                  <c:pt idx="0">
                    <c:v>2.30918913E-2</c:v>
                  </c:pt>
                  <c:pt idx="1">
                    <c:v>2.76380931E-2</c:v>
                  </c:pt>
                  <c:pt idx="2">
                    <c:v>2.4892048399999998E-2</c:v>
                  </c:pt>
                  <c:pt idx="3">
                    <c:v>4.0993792000000001E-2</c:v>
                  </c:pt>
                  <c:pt idx="4">
                    <c:v>4.4385060599999998E-2</c:v>
                  </c:pt>
                  <c:pt idx="5">
                    <c:v>3.3322201000000003E-2</c:v>
                  </c:pt>
                  <c:pt idx="6">
                    <c:v>4.4057110199999999E-2</c:v>
                  </c:pt>
                  <c:pt idx="7">
                    <c:v>3.8080773700000001E-2</c:v>
                  </c:pt>
                  <c:pt idx="8">
                    <c:v>3.5336485100000002E-2</c:v>
                  </c:pt>
                  <c:pt idx="9">
                    <c:v>3.63976367E-2</c:v>
                  </c:pt>
                  <c:pt idx="10">
                    <c:v>3.63206955E-2</c:v>
                  </c:pt>
                  <c:pt idx="11">
                    <c:v>4.76932339E-2</c:v>
                  </c:pt>
                  <c:pt idx="12">
                    <c:v>4.1401742599999999E-2</c:v>
                  </c:pt>
                  <c:pt idx="13">
                    <c:v>5.2477910900000001E-2</c:v>
                  </c:pt>
                </c:numCache>
              </c:numRef>
            </c:minus>
          </c:errBars>
          <c:xVal>
            <c:numRef>
              <c:f>wakeact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eact!$G$2:$G$15</c:f>
              <c:numCache>
                <c:formatCode>General</c:formatCode>
                <c:ptCount val="14"/>
                <c:pt idx="0">
                  <c:v>1.5552699544999999</c:v>
                </c:pt>
                <c:pt idx="1">
                  <c:v>1.5701745477</c:v>
                </c:pt>
                <c:pt idx="2">
                  <c:v>1.5726046026</c:v>
                </c:pt>
                <c:pt idx="3">
                  <c:v>1.8441000754000001</c:v>
                </c:pt>
                <c:pt idx="4">
                  <c:v>1.7756363264999999</c:v>
                </c:pt>
                <c:pt idx="5">
                  <c:v>1.7545994823</c:v>
                </c:pt>
                <c:pt idx="6">
                  <c:v>1.9012490050999999</c:v>
                </c:pt>
                <c:pt idx="7">
                  <c:v>1.8633321086000001</c:v>
                </c:pt>
                <c:pt idx="8">
                  <c:v>1.9680182500000001</c:v>
                </c:pt>
                <c:pt idx="9">
                  <c:v>1.5091884820999999</c:v>
                </c:pt>
                <c:pt idx="10">
                  <c:v>1.5644521407</c:v>
                </c:pt>
                <c:pt idx="11">
                  <c:v>1.5672929427</c:v>
                </c:pt>
                <c:pt idx="12">
                  <c:v>1.6569466892</c:v>
                </c:pt>
                <c:pt idx="13">
                  <c:v>1.6399612745000001</c:v>
                </c:pt>
              </c:numCache>
            </c:numRef>
          </c:yVal>
          <c:smooth val="0"/>
        </c:ser>
        <c:ser>
          <c:idx val="5"/>
          <c:order val="5"/>
          <c:tx>
            <c:strRef>
              <c:f>wakeact!$H$1</c:f>
              <c:strCache>
                <c:ptCount val="1"/>
                <c:pt idx="0">
                  <c:v>S2</c:v>
                </c:pt>
              </c:strCache>
            </c:strRef>
          </c:tx>
          <c:spPr>
            <a:ln w="19050">
              <a:solidFill>
                <a:srgbClr val="C00000"/>
              </a:solidFill>
            </a:ln>
          </c:spPr>
          <c:marker>
            <c:symbol val="square"/>
            <c:size val="4"/>
            <c:spPr>
              <a:solidFill>
                <a:srgbClr val="C00000"/>
              </a:solidFill>
              <a:ln>
                <a:solidFill>
                  <a:srgbClr val="C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wakeact!$Q$2:$Q$15</c:f>
                <c:numCache>
                  <c:formatCode>General</c:formatCode>
                  <c:ptCount val="14"/>
                  <c:pt idx="0">
                    <c:v>3.12168177E-2</c:v>
                  </c:pt>
                  <c:pt idx="1">
                    <c:v>2.79423847E-2</c:v>
                  </c:pt>
                  <c:pt idx="2">
                    <c:v>3.1260040699999998E-2</c:v>
                  </c:pt>
                  <c:pt idx="3">
                    <c:v>4.1119281399999999E-2</c:v>
                  </c:pt>
                  <c:pt idx="4">
                    <c:v>0.29391990070000001</c:v>
                  </c:pt>
                  <c:pt idx="5">
                    <c:v>3.6711924100000001E-2</c:v>
                  </c:pt>
                  <c:pt idx="6">
                    <c:v>3.8623445499999999E-2</c:v>
                  </c:pt>
                  <c:pt idx="7">
                    <c:v>4.6205349999999999E-2</c:v>
                  </c:pt>
                  <c:pt idx="8">
                    <c:v>4.7118692500000003E-2</c:v>
                  </c:pt>
                  <c:pt idx="9">
                    <c:v>4.5883469099999998E-2</c:v>
                  </c:pt>
                  <c:pt idx="10">
                    <c:v>4.8663470299999997E-2</c:v>
                  </c:pt>
                  <c:pt idx="11">
                    <c:v>4.5459518400000003E-2</c:v>
                  </c:pt>
                  <c:pt idx="12">
                    <c:v>4.28439397E-2</c:v>
                  </c:pt>
                  <c:pt idx="13">
                    <c:v>4.4701786399999999E-2</c:v>
                  </c:pt>
                </c:numCache>
              </c:numRef>
            </c:plus>
            <c:minus>
              <c:numRef>
                <c:f>wakeact!$Q$2:$Q$15</c:f>
                <c:numCache>
                  <c:formatCode>General</c:formatCode>
                  <c:ptCount val="14"/>
                  <c:pt idx="0">
                    <c:v>3.12168177E-2</c:v>
                  </c:pt>
                  <c:pt idx="1">
                    <c:v>2.79423847E-2</c:v>
                  </c:pt>
                  <c:pt idx="2">
                    <c:v>3.1260040699999998E-2</c:v>
                  </c:pt>
                  <c:pt idx="3">
                    <c:v>4.1119281399999999E-2</c:v>
                  </c:pt>
                  <c:pt idx="4">
                    <c:v>0.29391990070000001</c:v>
                  </c:pt>
                  <c:pt idx="5">
                    <c:v>3.6711924100000001E-2</c:v>
                  </c:pt>
                  <c:pt idx="6">
                    <c:v>3.8623445499999999E-2</c:v>
                  </c:pt>
                  <c:pt idx="7">
                    <c:v>4.6205349999999999E-2</c:v>
                  </c:pt>
                  <c:pt idx="8">
                    <c:v>4.7118692500000003E-2</c:v>
                  </c:pt>
                  <c:pt idx="9">
                    <c:v>4.5883469099999998E-2</c:v>
                  </c:pt>
                  <c:pt idx="10">
                    <c:v>4.8663470299999997E-2</c:v>
                  </c:pt>
                  <c:pt idx="11">
                    <c:v>4.5459518400000003E-2</c:v>
                  </c:pt>
                  <c:pt idx="12">
                    <c:v>4.28439397E-2</c:v>
                  </c:pt>
                  <c:pt idx="13">
                    <c:v>4.4701786399999999E-2</c:v>
                  </c:pt>
                </c:numCache>
              </c:numRef>
            </c:minus>
          </c:errBars>
          <c:xVal>
            <c:numRef>
              <c:f>wakeact!$B$2:$B$15</c:f>
              <c:numCache>
                <c:formatCode>General</c:formatCode>
                <c:ptCount val="14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</c:numCache>
            </c:numRef>
          </c:xVal>
          <c:yVal>
            <c:numRef>
              <c:f>wakeact!$H$2:$H$15</c:f>
              <c:numCache>
                <c:formatCode>General</c:formatCode>
                <c:ptCount val="14"/>
                <c:pt idx="0">
                  <c:v>1.658991696</c:v>
                </c:pt>
                <c:pt idx="1">
                  <c:v>1.5901784231</c:v>
                </c:pt>
                <c:pt idx="2">
                  <c:v>1.785364</c:v>
                </c:pt>
                <c:pt idx="3">
                  <c:v>1.8123333543</c:v>
                </c:pt>
                <c:pt idx="4">
                  <c:v>2.0970541457</c:v>
                </c:pt>
                <c:pt idx="5">
                  <c:v>1.7972042259000001</c:v>
                </c:pt>
                <c:pt idx="6">
                  <c:v>2.0674272738999999</c:v>
                </c:pt>
                <c:pt idx="7">
                  <c:v>2.0136323491999999</c:v>
                </c:pt>
                <c:pt idx="8">
                  <c:v>2.1413798491999998</c:v>
                </c:pt>
                <c:pt idx="9">
                  <c:v>1.9220022011</c:v>
                </c:pt>
                <c:pt idx="10">
                  <c:v>1.8005829291</c:v>
                </c:pt>
                <c:pt idx="11">
                  <c:v>1.9450723476</c:v>
                </c:pt>
                <c:pt idx="12">
                  <c:v>2.2282442916999998</c:v>
                </c:pt>
                <c:pt idx="13">
                  <c:v>1.96472928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8222720"/>
        <c:axId val="128224256"/>
      </c:scatterChart>
      <c:valAx>
        <c:axId val="128222720"/>
        <c:scaling>
          <c:orientation val="minMax"/>
          <c:max val="13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224256"/>
        <c:crosses val="autoZero"/>
        <c:crossBetween val="midCat"/>
        <c:majorUnit val="2"/>
      </c:valAx>
      <c:valAx>
        <c:axId val="128224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12822272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24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735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332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219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146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080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212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188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598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88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123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776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1C36C-2F98-4A3F-BF92-D80FFA89351E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B0E4A-3E89-40B7-A862-3D14ECE82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4307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460772"/>
            <a:ext cx="338554" cy="109260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smtClean="0"/>
              <a:t>Night bout </a:t>
            </a:r>
            <a:r>
              <a:rPr lang="en-US" sz="1000" dirty="0" smtClean="0"/>
              <a:t>number</a:t>
            </a:r>
            <a:endParaRPr lang="en-US" sz="1000" dirty="0"/>
          </a:p>
        </p:txBody>
      </p:sp>
      <p:sp>
        <p:nvSpPr>
          <p:cNvPr id="5" name="TextBox 4"/>
          <p:cNvSpPr txBox="1"/>
          <p:nvPr/>
        </p:nvSpPr>
        <p:spPr>
          <a:xfrm>
            <a:off x="91440" y="9144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407496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91440" y="228274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419698" y="228274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91440" y="45720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94660" y="460440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0709" y="4897829"/>
            <a:ext cx="338554" cy="14516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000" dirty="0" smtClean="0"/>
              <a:t>Waking activity (</a:t>
            </a:r>
            <a:r>
              <a:rPr lang="en-US" sz="1000" dirty="0" err="1" smtClean="0"/>
              <a:t>cts</a:t>
            </a:r>
            <a:r>
              <a:rPr lang="en-US" sz="1000" dirty="0" smtClean="0"/>
              <a:t>./min.)</a:t>
            </a:r>
            <a:endParaRPr lang="en-US" sz="1000" dirty="0"/>
          </a:p>
        </p:txBody>
      </p:sp>
      <p:sp>
        <p:nvSpPr>
          <p:cNvPr id="12" name="TextBox 11"/>
          <p:cNvSpPr txBox="1"/>
          <p:nvPr/>
        </p:nvSpPr>
        <p:spPr>
          <a:xfrm>
            <a:off x="100709" y="2605616"/>
            <a:ext cx="338554" cy="153022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000" dirty="0" smtClean="0"/>
              <a:t>Day avg. </a:t>
            </a:r>
            <a:r>
              <a:rPr lang="en-US" sz="1000" dirty="0" smtClean="0"/>
              <a:t>bout  </a:t>
            </a:r>
            <a:r>
              <a:rPr lang="en-US" sz="1000" dirty="0" smtClean="0"/>
              <a:t>length (min.)</a:t>
            </a:r>
            <a:endParaRPr lang="en-US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3463800" y="2599014"/>
            <a:ext cx="338554" cy="137473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000" dirty="0" smtClean="0"/>
              <a:t>Day avg. </a:t>
            </a:r>
            <a:r>
              <a:rPr lang="en-US" sz="1000" dirty="0" smtClean="0"/>
              <a:t>bout </a:t>
            </a:r>
            <a:r>
              <a:rPr lang="en-US" sz="1000" dirty="0" smtClean="0"/>
              <a:t>l</a:t>
            </a:r>
            <a:r>
              <a:rPr lang="en-US" sz="1000" dirty="0" smtClean="0"/>
              <a:t>ength </a:t>
            </a:r>
            <a:r>
              <a:rPr lang="en-US" sz="1000" i="1" dirty="0" smtClean="0"/>
              <a:t>CV</a:t>
            </a:r>
            <a:r>
              <a:rPr lang="en-US" sz="1000" baseline="-25000" dirty="0" smtClean="0"/>
              <a:t>E</a:t>
            </a:r>
            <a:endParaRPr lang="en-US" sz="1000" baseline="-25000" dirty="0"/>
          </a:p>
        </p:txBody>
      </p:sp>
      <p:sp>
        <p:nvSpPr>
          <p:cNvPr id="14" name="TextBox 13"/>
          <p:cNvSpPr txBox="1"/>
          <p:nvPr/>
        </p:nvSpPr>
        <p:spPr>
          <a:xfrm>
            <a:off x="3540744" y="5066345"/>
            <a:ext cx="338554" cy="10958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smtClean="0"/>
              <a:t>Waking activity </a:t>
            </a:r>
            <a:r>
              <a:rPr lang="en-US" sz="1000" i="1" dirty="0" smtClean="0"/>
              <a:t>CV</a:t>
            </a:r>
            <a:r>
              <a:rPr lang="en-US" sz="1000" baseline="-25000" dirty="0" smtClean="0"/>
              <a:t>E</a:t>
            </a:r>
            <a:endParaRPr lang="en-US" sz="1000" baseline="-25000" dirty="0"/>
          </a:p>
        </p:txBody>
      </p:sp>
      <p:sp>
        <p:nvSpPr>
          <p:cNvPr id="15" name="TextBox 14"/>
          <p:cNvSpPr txBox="1"/>
          <p:nvPr/>
        </p:nvSpPr>
        <p:spPr>
          <a:xfrm>
            <a:off x="3540744" y="371900"/>
            <a:ext cx="338554" cy="130260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smtClean="0"/>
              <a:t>Night bout number </a:t>
            </a:r>
            <a:r>
              <a:rPr lang="en-US" sz="1000" i="1" dirty="0" smtClean="0"/>
              <a:t>CV</a:t>
            </a:r>
            <a:r>
              <a:rPr lang="en-US" sz="1000" baseline="-25000" dirty="0" smtClean="0"/>
              <a:t>E</a:t>
            </a:r>
            <a:endParaRPr lang="en-US" sz="1000" baseline="-25000" dirty="0"/>
          </a:p>
        </p:txBody>
      </p:sp>
      <p:graphicFrame>
        <p:nvGraphicFramePr>
          <p:cNvPr id="16" name="Chart 15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122776098"/>
              </p:ext>
            </p:extLst>
          </p:nvPr>
        </p:nvGraphicFramePr>
        <p:xfrm>
          <a:off x="3776472" y="2468880"/>
          <a:ext cx="2743200" cy="1990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Chart 16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494532706"/>
              </p:ext>
            </p:extLst>
          </p:nvPr>
        </p:nvGraphicFramePr>
        <p:xfrm>
          <a:off x="3776472" y="91440"/>
          <a:ext cx="2743200" cy="1990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Chart 17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867851930"/>
              </p:ext>
            </p:extLst>
          </p:nvPr>
        </p:nvGraphicFramePr>
        <p:xfrm>
          <a:off x="3776472" y="4663440"/>
          <a:ext cx="2743200" cy="1990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8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89970256"/>
              </p:ext>
            </p:extLst>
          </p:nvPr>
        </p:nvGraphicFramePr>
        <p:xfrm>
          <a:off x="365760" y="2468880"/>
          <a:ext cx="2743200" cy="1990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Chart 19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993890165"/>
              </p:ext>
            </p:extLst>
          </p:nvPr>
        </p:nvGraphicFramePr>
        <p:xfrm>
          <a:off x="429768" y="91440"/>
          <a:ext cx="2743200" cy="1990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1" name="Chart 20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072968995"/>
              </p:ext>
            </p:extLst>
          </p:nvPr>
        </p:nvGraphicFramePr>
        <p:xfrm>
          <a:off x="384048" y="4663440"/>
          <a:ext cx="2743200" cy="19904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323975" y="6567845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eneration</a:t>
            </a:r>
            <a:endParaRPr lang="en-US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4876800" y="6567845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Generation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365114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39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HLB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bison, Susan (NIH/NHLBI) [E]</dc:creator>
  <cp:lastModifiedBy>Harbison, Susan (NIH/NHLBI) [E]</cp:lastModifiedBy>
  <cp:revision>7</cp:revision>
  <dcterms:created xsi:type="dcterms:W3CDTF">2016-10-22T18:40:28Z</dcterms:created>
  <dcterms:modified xsi:type="dcterms:W3CDTF">2016-10-25T13:43:58Z</dcterms:modified>
</cp:coreProperties>
</file>